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</p:sldIdLst>
  <p:sldSz cx="9007475" cy="606266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804E06-A410-4343-AA9A-A3074A2521B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1133280" y="545760"/>
            <a:ext cx="7675560" cy="100980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b">
            <a:noAutofit/>
          </a:bodyPr>
          <a:p>
            <a:pPr indent="0" algn="ctr">
              <a:buNone/>
              <a:tabLst>
                <a:tab algn="l" pos="0"/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4000" spc="-1" strike="noStrike">
              <a:solidFill>
                <a:srgbClr val="ffea18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1165320" y="1784520"/>
            <a:ext cx="7656480" cy="173448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1165320" y="3684240"/>
            <a:ext cx="7656480" cy="173448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C25053-1836-4686-B87B-4F4AB87B3B8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1133280" y="545760"/>
            <a:ext cx="7675560" cy="100980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b">
            <a:noAutofit/>
          </a:bodyPr>
          <a:p>
            <a:pPr indent="0" algn="ctr">
              <a:buNone/>
              <a:tabLst>
                <a:tab algn="l" pos="0"/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4000" spc="-1" strike="noStrike">
              <a:solidFill>
                <a:srgbClr val="ffea18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1165320" y="1784520"/>
            <a:ext cx="3736080" cy="173448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088600" y="1784520"/>
            <a:ext cx="3736080" cy="173448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1165320" y="3684240"/>
            <a:ext cx="3736080" cy="173448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088600" y="3684240"/>
            <a:ext cx="3736080" cy="173448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B81A69-B76E-439A-A25C-C976B8E8712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1133280" y="545760"/>
            <a:ext cx="7675560" cy="100980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b">
            <a:noAutofit/>
          </a:bodyPr>
          <a:p>
            <a:pPr indent="0" algn="ctr">
              <a:buNone/>
              <a:tabLst>
                <a:tab algn="l" pos="0"/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4000" spc="-1" strike="noStrike">
              <a:solidFill>
                <a:srgbClr val="ffea18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1165320" y="1784520"/>
            <a:ext cx="2465280" cy="173448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754080" y="1784520"/>
            <a:ext cx="2465280" cy="173448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343200" y="1784520"/>
            <a:ext cx="2465280" cy="173448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1165320" y="3684240"/>
            <a:ext cx="2465280" cy="173448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754080" y="3684240"/>
            <a:ext cx="2465280" cy="173448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343200" y="3684240"/>
            <a:ext cx="2465280" cy="173448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46765D-7DA6-4B9C-BC89-BF150F6E222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C20CA8C-531D-43C5-945C-0422184CE79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title"/>
          </p:nvPr>
        </p:nvSpPr>
        <p:spPr>
          <a:xfrm>
            <a:off x="1133280" y="545760"/>
            <a:ext cx="7675560" cy="100980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b">
            <a:noAutofit/>
          </a:bodyPr>
          <a:p>
            <a:pPr indent="0" algn="ctr">
              <a:buNone/>
              <a:tabLst>
                <a:tab algn="l" pos="0"/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4000" spc="-1" strike="noStrike">
              <a:solidFill>
                <a:srgbClr val="ffea18"/>
              </a:solidFill>
              <a:latin typeface="Arial"/>
            </a:endParaRPr>
          </a:p>
        </p:txBody>
      </p:sp>
      <p:sp>
        <p:nvSpPr>
          <p:cNvPr id="55" name="PlaceHolder 2"/>
          <p:cNvSpPr>
            <a:spLocks noGrp="1"/>
          </p:cNvSpPr>
          <p:nvPr>
            <p:ph type="subTitle"/>
          </p:nvPr>
        </p:nvSpPr>
        <p:spPr>
          <a:xfrm>
            <a:off x="1165320" y="1784520"/>
            <a:ext cx="7656480" cy="3636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26"/>
              </a:spcBef>
              <a:buNone/>
              <a:tabLst>
                <a:tab algn="l" pos="0"/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8A50978-E051-4045-922A-681056D0044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PlaceHolder 1"/>
          <p:cNvSpPr>
            <a:spLocks noGrp="1"/>
          </p:cNvSpPr>
          <p:nvPr>
            <p:ph type="title"/>
          </p:nvPr>
        </p:nvSpPr>
        <p:spPr>
          <a:xfrm>
            <a:off x="1133280" y="545760"/>
            <a:ext cx="7675560" cy="100980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b">
            <a:noAutofit/>
          </a:bodyPr>
          <a:p>
            <a:pPr indent="0" algn="ctr">
              <a:buNone/>
              <a:tabLst>
                <a:tab algn="l" pos="0"/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4000" spc="-1" strike="noStrike">
              <a:solidFill>
                <a:srgbClr val="ffea18"/>
              </a:solidFill>
              <a:latin typeface="Arial"/>
            </a:endParaRPr>
          </a:p>
        </p:txBody>
      </p:sp>
      <p:sp>
        <p:nvSpPr>
          <p:cNvPr id="57" name="PlaceHolder 2"/>
          <p:cNvSpPr>
            <a:spLocks noGrp="1"/>
          </p:cNvSpPr>
          <p:nvPr>
            <p:ph/>
          </p:nvPr>
        </p:nvSpPr>
        <p:spPr>
          <a:xfrm>
            <a:off x="1165320" y="1784520"/>
            <a:ext cx="7656480" cy="363672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803E325-1AE1-48C1-A910-0CEEECB91B5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PlaceHolder 1"/>
          <p:cNvSpPr>
            <a:spLocks noGrp="1"/>
          </p:cNvSpPr>
          <p:nvPr>
            <p:ph type="title"/>
          </p:nvPr>
        </p:nvSpPr>
        <p:spPr>
          <a:xfrm>
            <a:off x="1133280" y="545760"/>
            <a:ext cx="7675560" cy="100980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b">
            <a:noAutofit/>
          </a:bodyPr>
          <a:p>
            <a:pPr indent="0" algn="ctr">
              <a:buNone/>
              <a:tabLst>
                <a:tab algn="l" pos="0"/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4000" spc="-1" strike="noStrike">
              <a:solidFill>
                <a:srgbClr val="ffea18"/>
              </a:solidFill>
              <a:latin typeface="Arial"/>
            </a:endParaRPr>
          </a:p>
        </p:txBody>
      </p:sp>
      <p:sp>
        <p:nvSpPr>
          <p:cNvPr id="59" name="PlaceHolder 2"/>
          <p:cNvSpPr>
            <a:spLocks noGrp="1"/>
          </p:cNvSpPr>
          <p:nvPr>
            <p:ph/>
          </p:nvPr>
        </p:nvSpPr>
        <p:spPr>
          <a:xfrm>
            <a:off x="1165320" y="1784520"/>
            <a:ext cx="3736080" cy="363672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0" name="PlaceHolder 3"/>
          <p:cNvSpPr>
            <a:spLocks noGrp="1"/>
          </p:cNvSpPr>
          <p:nvPr>
            <p:ph/>
          </p:nvPr>
        </p:nvSpPr>
        <p:spPr>
          <a:xfrm>
            <a:off x="5088600" y="1784520"/>
            <a:ext cx="3736080" cy="363672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CFF06AB-122B-434A-A86E-4F94F363306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title"/>
          </p:nvPr>
        </p:nvSpPr>
        <p:spPr>
          <a:xfrm>
            <a:off x="1133280" y="545760"/>
            <a:ext cx="7675560" cy="100980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b">
            <a:noAutofit/>
          </a:bodyPr>
          <a:p>
            <a:pPr indent="0" algn="ctr">
              <a:buNone/>
              <a:tabLst>
                <a:tab algn="l" pos="0"/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4000" spc="-1" strike="noStrike">
              <a:solidFill>
                <a:srgbClr val="ffea18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4C89DCA-FDDC-4496-A2AA-B3A19B48D25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PlaceHolder 1"/>
          <p:cNvSpPr>
            <a:spLocks noGrp="1"/>
          </p:cNvSpPr>
          <p:nvPr>
            <p:ph type="subTitle"/>
          </p:nvPr>
        </p:nvSpPr>
        <p:spPr>
          <a:xfrm>
            <a:off x="1133280" y="545760"/>
            <a:ext cx="7675560" cy="4682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26"/>
              </a:spcBef>
              <a:tabLst>
                <a:tab algn="l" pos="0"/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386E8D2-674A-4CA5-BD15-58391C28136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1133280" y="545760"/>
            <a:ext cx="7675560" cy="100980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b">
            <a:noAutofit/>
          </a:bodyPr>
          <a:p>
            <a:pPr indent="0" algn="ctr">
              <a:buNone/>
              <a:tabLst>
                <a:tab algn="l" pos="0"/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4000" spc="-1" strike="noStrike">
              <a:solidFill>
                <a:srgbClr val="ffea18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1165320" y="1784520"/>
            <a:ext cx="3736080" cy="173448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5088600" y="1784520"/>
            <a:ext cx="3736080" cy="363672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1165320" y="3684240"/>
            <a:ext cx="3736080" cy="173448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60FC05A-7CF5-41A1-BD7F-0FBC5BDF3B9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1133280" y="545760"/>
            <a:ext cx="7675560" cy="100980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b">
            <a:noAutofit/>
          </a:bodyPr>
          <a:p>
            <a:pPr indent="0" algn="ctr">
              <a:buNone/>
              <a:tabLst>
                <a:tab algn="l" pos="0"/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4000" spc="-1" strike="noStrike">
              <a:solidFill>
                <a:srgbClr val="ffea18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1165320" y="1784520"/>
            <a:ext cx="7656480" cy="3636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26"/>
              </a:spcBef>
              <a:buNone/>
              <a:tabLst>
                <a:tab algn="l" pos="0"/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2DA885-A98D-4036-990D-285641C07D2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1133280" y="545760"/>
            <a:ext cx="7675560" cy="100980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b">
            <a:noAutofit/>
          </a:bodyPr>
          <a:p>
            <a:pPr indent="0" algn="ctr">
              <a:buNone/>
              <a:tabLst>
                <a:tab algn="l" pos="0"/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4000" spc="-1" strike="noStrike">
              <a:solidFill>
                <a:srgbClr val="ffea18"/>
              </a:solidFill>
              <a:latin typeface="Arial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1165320" y="1784520"/>
            <a:ext cx="3736080" cy="363672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5088600" y="1784520"/>
            <a:ext cx="3736080" cy="173448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0" name="PlaceHolder 4"/>
          <p:cNvSpPr>
            <a:spLocks noGrp="1"/>
          </p:cNvSpPr>
          <p:nvPr>
            <p:ph/>
          </p:nvPr>
        </p:nvSpPr>
        <p:spPr>
          <a:xfrm>
            <a:off x="5088600" y="3684240"/>
            <a:ext cx="3736080" cy="173448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B281157-5782-42A1-B1D3-737BCAB5F7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PlaceHolder 1"/>
          <p:cNvSpPr>
            <a:spLocks noGrp="1"/>
          </p:cNvSpPr>
          <p:nvPr>
            <p:ph type="title"/>
          </p:nvPr>
        </p:nvSpPr>
        <p:spPr>
          <a:xfrm>
            <a:off x="1133280" y="545760"/>
            <a:ext cx="7675560" cy="100980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b">
            <a:noAutofit/>
          </a:bodyPr>
          <a:p>
            <a:pPr indent="0" algn="ctr">
              <a:buNone/>
              <a:tabLst>
                <a:tab algn="l" pos="0"/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4000" spc="-1" strike="noStrike">
              <a:solidFill>
                <a:srgbClr val="ffea18"/>
              </a:solidFill>
              <a:latin typeface="Arial"/>
            </a:endParaRPr>
          </a:p>
        </p:txBody>
      </p:sp>
      <p:sp>
        <p:nvSpPr>
          <p:cNvPr id="72" name="PlaceHolder 2"/>
          <p:cNvSpPr>
            <a:spLocks noGrp="1"/>
          </p:cNvSpPr>
          <p:nvPr>
            <p:ph/>
          </p:nvPr>
        </p:nvSpPr>
        <p:spPr>
          <a:xfrm>
            <a:off x="1165320" y="1784520"/>
            <a:ext cx="3736080" cy="173448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3" name="PlaceHolder 3"/>
          <p:cNvSpPr>
            <a:spLocks noGrp="1"/>
          </p:cNvSpPr>
          <p:nvPr>
            <p:ph/>
          </p:nvPr>
        </p:nvSpPr>
        <p:spPr>
          <a:xfrm>
            <a:off x="5088600" y="1784520"/>
            <a:ext cx="3736080" cy="173448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4" name="PlaceHolder 4"/>
          <p:cNvSpPr>
            <a:spLocks noGrp="1"/>
          </p:cNvSpPr>
          <p:nvPr>
            <p:ph/>
          </p:nvPr>
        </p:nvSpPr>
        <p:spPr>
          <a:xfrm>
            <a:off x="1165320" y="3684240"/>
            <a:ext cx="7656480" cy="173448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8E0F363-8507-4360-843C-942418803F5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1133280" y="545760"/>
            <a:ext cx="7675560" cy="100980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b">
            <a:noAutofit/>
          </a:bodyPr>
          <a:p>
            <a:pPr indent="0" algn="ctr">
              <a:buNone/>
              <a:tabLst>
                <a:tab algn="l" pos="0"/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4000" spc="-1" strike="noStrike">
              <a:solidFill>
                <a:srgbClr val="ffea18"/>
              </a:solidFill>
              <a:latin typeface="Arial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1165320" y="1784520"/>
            <a:ext cx="7656480" cy="173448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1165320" y="3684240"/>
            <a:ext cx="7656480" cy="173448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50DE99A-B2B3-42BD-AA13-35C1C7AE4DF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PlaceHolder 1"/>
          <p:cNvSpPr>
            <a:spLocks noGrp="1"/>
          </p:cNvSpPr>
          <p:nvPr>
            <p:ph type="title"/>
          </p:nvPr>
        </p:nvSpPr>
        <p:spPr>
          <a:xfrm>
            <a:off x="1133280" y="545760"/>
            <a:ext cx="7675560" cy="100980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b">
            <a:noAutofit/>
          </a:bodyPr>
          <a:p>
            <a:pPr indent="0" algn="ctr">
              <a:buNone/>
              <a:tabLst>
                <a:tab algn="l" pos="0"/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4000" spc="-1" strike="noStrike">
              <a:solidFill>
                <a:srgbClr val="ffea18"/>
              </a:solidFill>
              <a:latin typeface="Arial"/>
            </a:endParaRPr>
          </a:p>
        </p:txBody>
      </p:sp>
      <p:sp>
        <p:nvSpPr>
          <p:cNvPr id="79" name="PlaceHolder 2"/>
          <p:cNvSpPr>
            <a:spLocks noGrp="1"/>
          </p:cNvSpPr>
          <p:nvPr>
            <p:ph/>
          </p:nvPr>
        </p:nvSpPr>
        <p:spPr>
          <a:xfrm>
            <a:off x="1165320" y="1784520"/>
            <a:ext cx="3736080" cy="173448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0" name="PlaceHolder 3"/>
          <p:cNvSpPr>
            <a:spLocks noGrp="1"/>
          </p:cNvSpPr>
          <p:nvPr>
            <p:ph/>
          </p:nvPr>
        </p:nvSpPr>
        <p:spPr>
          <a:xfrm>
            <a:off x="5088600" y="1784520"/>
            <a:ext cx="3736080" cy="173448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1" name="PlaceHolder 4"/>
          <p:cNvSpPr>
            <a:spLocks noGrp="1"/>
          </p:cNvSpPr>
          <p:nvPr>
            <p:ph/>
          </p:nvPr>
        </p:nvSpPr>
        <p:spPr>
          <a:xfrm>
            <a:off x="1165320" y="3684240"/>
            <a:ext cx="3736080" cy="173448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2" name="PlaceHolder 5"/>
          <p:cNvSpPr>
            <a:spLocks noGrp="1"/>
          </p:cNvSpPr>
          <p:nvPr>
            <p:ph/>
          </p:nvPr>
        </p:nvSpPr>
        <p:spPr>
          <a:xfrm>
            <a:off x="5088600" y="3684240"/>
            <a:ext cx="3736080" cy="173448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CE9975C-E1FB-4625-AFF1-A516A500106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PlaceHolder 1"/>
          <p:cNvSpPr>
            <a:spLocks noGrp="1"/>
          </p:cNvSpPr>
          <p:nvPr>
            <p:ph type="title"/>
          </p:nvPr>
        </p:nvSpPr>
        <p:spPr>
          <a:xfrm>
            <a:off x="1133280" y="545760"/>
            <a:ext cx="7675560" cy="100980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b">
            <a:noAutofit/>
          </a:bodyPr>
          <a:p>
            <a:pPr indent="0" algn="ctr">
              <a:buNone/>
              <a:tabLst>
                <a:tab algn="l" pos="0"/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4000" spc="-1" strike="noStrike">
              <a:solidFill>
                <a:srgbClr val="ffea18"/>
              </a:solidFill>
              <a:latin typeface="Arial"/>
            </a:endParaRPr>
          </a:p>
        </p:txBody>
      </p:sp>
      <p:sp>
        <p:nvSpPr>
          <p:cNvPr id="84" name="PlaceHolder 2"/>
          <p:cNvSpPr>
            <a:spLocks noGrp="1"/>
          </p:cNvSpPr>
          <p:nvPr>
            <p:ph/>
          </p:nvPr>
        </p:nvSpPr>
        <p:spPr>
          <a:xfrm>
            <a:off x="1165320" y="1784520"/>
            <a:ext cx="2465280" cy="173448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5" name="PlaceHolder 3"/>
          <p:cNvSpPr>
            <a:spLocks noGrp="1"/>
          </p:cNvSpPr>
          <p:nvPr>
            <p:ph/>
          </p:nvPr>
        </p:nvSpPr>
        <p:spPr>
          <a:xfrm>
            <a:off x="3754080" y="1784520"/>
            <a:ext cx="2465280" cy="173448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6" name="PlaceHolder 4"/>
          <p:cNvSpPr>
            <a:spLocks noGrp="1"/>
          </p:cNvSpPr>
          <p:nvPr>
            <p:ph/>
          </p:nvPr>
        </p:nvSpPr>
        <p:spPr>
          <a:xfrm>
            <a:off x="6343200" y="1784520"/>
            <a:ext cx="2465280" cy="173448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7" name="PlaceHolder 5"/>
          <p:cNvSpPr>
            <a:spLocks noGrp="1"/>
          </p:cNvSpPr>
          <p:nvPr>
            <p:ph/>
          </p:nvPr>
        </p:nvSpPr>
        <p:spPr>
          <a:xfrm>
            <a:off x="1165320" y="3684240"/>
            <a:ext cx="2465280" cy="173448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8" name="PlaceHolder 6"/>
          <p:cNvSpPr>
            <a:spLocks noGrp="1"/>
          </p:cNvSpPr>
          <p:nvPr>
            <p:ph/>
          </p:nvPr>
        </p:nvSpPr>
        <p:spPr>
          <a:xfrm>
            <a:off x="3754080" y="3684240"/>
            <a:ext cx="2465280" cy="173448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9" name="PlaceHolder 7"/>
          <p:cNvSpPr>
            <a:spLocks noGrp="1"/>
          </p:cNvSpPr>
          <p:nvPr>
            <p:ph/>
          </p:nvPr>
        </p:nvSpPr>
        <p:spPr>
          <a:xfrm>
            <a:off x="6343200" y="3684240"/>
            <a:ext cx="2465280" cy="173448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4A1C2E3-D7F1-472A-82D9-DF6FC0C25C0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1133280" y="545760"/>
            <a:ext cx="7675560" cy="100980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b">
            <a:noAutofit/>
          </a:bodyPr>
          <a:p>
            <a:pPr indent="0" algn="ctr">
              <a:buNone/>
              <a:tabLst>
                <a:tab algn="l" pos="0"/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4000" spc="-1" strike="noStrike">
              <a:solidFill>
                <a:srgbClr val="ffea18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1165320" y="1784520"/>
            <a:ext cx="7656480" cy="363672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E28DEC-B1AE-41C6-B801-ACF32D92AAC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1133280" y="545760"/>
            <a:ext cx="7675560" cy="100980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b">
            <a:noAutofit/>
          </a:bodyPr>
          <a:p>
            <a:pPr indent="0" algn="ctr">
              <a:buNone/>
              <a:tabLst>
                <a:tab algn="l" pos="0"/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4000" spc="-1" strike="noStrike">
              <a:solidFill>
                <a:srgbClr val="ffea18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1165320" y="1784520"/>
            <a:ext cx="3736080" cy="363672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088600" y="1784520"/>
            <a:ext cx="3736080" cy="363672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07BB12-827F-4F3B-9FBF-B87C9C7234E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1133280" y="545760"/>
            <a:ext cx="7675560" cy="100980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b">
            <a:noAutofit/>
          </a:bodyPr>
          <a:p>
            <a:pPr indent="0" algn="ctr">
              <a:buNone/>
              <a:tabLst>
                <a:tab algn="l" pos="0"/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4000" spc="-1" strike="noStrike">
              <a:solidFill>
                <a:srgbClr val="ffea18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03FBF8-585F-47B8-8A9F-DB07FFADAAB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1133280" y="545760"/>
            <a:ext cx="7675560" cy="4682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26"/>
              </a:spcBef>
              <a:tabLst>
                <a:tab algn="l" pos="0"/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3C7264-15D5-41B4-BAF6-4B3CFC0C711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1133280" y="545760"/>
            <a:ext cx="7675560" cy="100980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b">
            <a:noAutofit/>
          </a:bodyPr>
          <a:p>
            <a:pPr indent="0" algn="ctr">
              <a:buNone/>
              <a:tabLst>
                <a:tab algn="l" pos="0"/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4000" spc="-1" strike="noStrike">
              <a:solidFill>
                <a:srgbClr val="ffea18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1165320" y="1784520"/>
            <a:ext cx="3736080" cy="173448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088600" y="1784520"/>
            <a:ext cx="3736080" cy="363672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1165320" y="3684240"/>
            <a:ext cx="3736080" cy="173448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403B1E-A77F-47B9-ADD2-4B0418BE2C5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1133280" y="545760"/>
            <a:ext cx="7675560" cy="100980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b">
            <a:noAutofit/>
          </a:bodyPr>
          <a:p>
            <a:pPr indent="0" algn="ctr">
              <a:buNone/>
              <a:tabLst>
                <a:tab algn="l" pos="0"/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4000" spc="-1" strike="noStrike">
              <a:solidFill>
                <a:srgbClr val="ffea18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1165320" y="1784520"/>
            <a:ext cx="3736080" cy="363672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088600" y="1784520"/>
            <a:ext cx="3736080" cy="173448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088600" y="3684240"/>
            <a:ext cx="3736080" cy="173448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E5FDCE-6A1F-4738-BDC8-33D3CF2EF9F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1133280" y="545760"/>
            <a:ext cx="7675560" cy="100980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b">
            <a:noAutofit/>
          </a:bodyPr>
          <a:p>
            <a:pPr indent="0" algn="ctr">
              <a:buNone/>
              <a:tabLst>
                <a:tab algn="l" pos="0"/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4000" spc="-1" strike="noStrike">
              <a:solidFill>
                <a:srgbClr val="ffea18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1165320" y="1784520"/>
            <a:ext cx="3736080" cy="173448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088600" y="1784520"/>
            <a:ext cx="3736080" cy="173448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1165320" y="3684240"/>
            <a:ext cx="7656480" cy="173448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11F6D8-C348-4878-8B03-9A4AC504CD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1133280" y="545760"/>
            <a:ext cx="7675560" cy="100980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b">
            <a:noAutofit/>
          </a:bodyPr>
          <a:p>
            <a:pPr indent="0" algn="ctr">
              <a:buNone/>
              <a:tabLst>
                <a:tab algn="l" pos="0"/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r>
              <a:rPr b="1" lang="en-US" sz="4000" spc="-1" strike="noStrike">
                <a:solidFill>
                  <a:srgbClr val="ffea18"/>
                </a:solidFill>
                <a:latin typeface="Arial"/>
              </a:rPr>
              <a:t>Click to edit the title text format</a:t>
            </a:r>
            <a:endParaRPr b="1" lang="en-US" sz="4000" spc="-1" strike="noStrike">
              <a:solidFill>
                <a:srgbClr val="ffea18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1165320" y="1784520"/>
            <a:ext cx="7656480" cy="363672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t">
            <a:normAutofit fontScale="97000"/>
          </a:bodyPr>
          <a:p>
            <a:pPr marL="309240" indent="-309240">
              <a:spcBef>
                <a:spcPts val="726"/>
              </a:spcBef>
              <a:buClr>
                <a:srgbClr val="ffea18"/>
              </a:buClr>
              <a:buSzPct val="105000"/>
              <a:buFont typeface="Times"/>
              <a:buChar char="•"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r>
              <a:rPr b="1" lang="en-US" sz="2900" spc="-1" strike="noStrike">
                <a:solidFill>
                  <a:srgbClr val="ffffff"/>
                </a:solidFill>
                <a:latin typeface="Arial"/>
              </a:rPr>
              <a:t>Click to edit the outline text format</a:t>
            </a: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  <a:p>
            <a:pPr lvl="1" marL="668160" indent="-257040">
              <a:spcBef>
                <a:spcPts val="726"/>
              </a:spcBef>
              <a:buClr>
                <a:srgbClr val="ffea18"/>
              </a:buClr>
              <a:buSzPct val="105000"/>
              <a:buFont typeface="Times"/>
              <a:buChar char="–"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r>
              <a:rPr b="1" lang="en-US" sz="2900" spc="-1" strike="noStrike">
                <a:solidFill>
                  <a:srgbClr val="ffffff"/>
                </a:solidFill>
                <a:latin typeface="Arial"/>
              </a:rPr>
              <a:t>Second Outline Level</a:t>
            </a: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  <a:p>
            <a:pPr lvl="2" marL="1028520" indent="-206280">
              <a:spcBef>
                <a:spcPts val="726"/>
              </a:spcBef>
              <a:buClr>
                <a:srgbClr val="ffea18"/>
              </a:buClr>
              <a:buSzPct val="105000"/>
              <a:buFont typeface="Times"/>
              <a:buChar char="•"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r>
              <a:rPr b="1" lang="en-US" sz="2900" spc="-1" strike="noStrike">
                <a:solidFill>
                  <a:srgbClr val="ffffff"/>
                </a:solidFill>
                <a:latin typeface="Arial"/>
              </a:rPr>
              <a:t>Third Outline Level</a:t>
            </a: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  <a:p>
            <a:pPr lvl="3" marL="1438200" indent="-206280">
              <a:spcBef>
                <a:spcPts val="726"/>
              </a:spcBef>
              <a:buClr>
                <a:srgbClr val="ffea18"/>
              </a:buClr>
              <a:buSzPct val="105000"/>
              <a:buFont typeface="Times"/>
              <a:buChar char="•"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r>
              <a:rPr b="1" lang="en-US" sz="2900" spc="-1" strike="noStrike">
                <a:solidFill>
                  <a:srgbClr val="ffffff"/>
                </a:solidFill>
                <a:latin typeface="Arial"/>
              </a:rPr>
              <a:t>Fourth Outline Level</a:t>
            </a: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  <a:p>
            <a:pPr lvl="4" marL="1850760" indent="-205920">
              <a:spcBef>
                <a:spcPts val="726"/>
              </a:spcBef>
              <a:buClr>
                <a:srgbClr val="ffea18"/>
              </a:buClr>
              <a:buSzPct val="105000"/>
              <a:buFont typeface="Times"/>
              <a:buChar char="•"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r>
              <a:rPr b="1" lang="en-US" sz="2900" spc="-1" strike="noStrike">
                <a:solidFill>
                  <a:srgbClr val="ffffff"/>
                </a:solidFill>
                <a:latin typeface="Arial"/>
              </a:rPr>
              <a:t>Fifth Outline Level</a:t>
            </a: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  <a:p>
            <a:pPr lvl="5" marL="1850760" indent="-205920">
              <a:spcBef>
                <a:spcPts val="726"/>
              </a:spcBef>
              <a:buClr>
                <a:srgbClr val="ffffff"/>
              </a:buClr>
              <a:buSzPct val="105000"/>
              <a:buFont typeface="Times"/>
              <a:buChar char="•"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r>
              <a:rPr b="1" lang="en-US" sz="2900" spc="-1" strike="noStrike">
                <a:solidFill>
                  <a:srgbClr val="ffffff"/>
                </a:solidFill>
                <a:latin typeface="Arial"/>
              </a:rPr>
              <a:t>Sixth Outline Level</a:t>
            </a: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  <a:p>
            <a:pPr lvl="6" marL="1850760" indent="-205920">
              <a:spcBef>
                <a:spcPts val="726"/>
              </a:spcBef>
              <a:buClr>
                <a:srgbClr val="ffffff"/>
              </a:buClr>
              <a:buSzPct val="105000"/>
              <a:buFont typeface="Times"/>
              <a:buChar char="•"/>
              <a:tabLst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r>
              <a:rPr b="1" lang="en-US" sz="2900" spc="-1" strike="noStrike">
                <a:solidFill>
                  <a:srgbClr val="ffffff"/>
                </a:solidFill>
                <a:latin typeface="Arial"/>
              </a:rPr>
              <a:t>Seventh Outline Level</a:t>
            </a:r>
            <a:endParaRPr b="1" lang="en-US" sz="2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99640" y="5590800"/>
            <a:ext cx="1878120" cy="40500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b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  <a:defRPr b="0" lang="en-US" sz="1300" spc="-1" strike="noStrike">
                <a:solidFill>
                  <a:srgbClr val="ffffff"/>
                </a:solidFill>
                <a:latin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r>
              <a:rPr b="0" lang="en-US" sz="1300" spc="-1" strike="noStrike">
                <a:solidFill>
                  <a:srgbClr val="ffffff"/>
                </a:solidFill>
                <a:latin typeface="Arial"/>
              </a:rPr>
              <a:t>&lt;date/time&gt;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301560" y="5590800"/>
            <a:ext cx="2854440" cy="40500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b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  <a:defRPr b="0" lang="en-US" sz="1300" spc="-1" strike="noStrike">
                <a:solidFill>
                  <a:srgbClr val="ffffff"/>
                </a:solidFill>
                <a:latin typeface="Arial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r>
              <a:rPr b="0" lang="en-US" sz="1300" spc="-1" strike="noStrike">
                <a:solidFill>
                  <a:srgbClr val="ffffff"/>
                </a:solidFill>
                <a:latin typeface="Arial"/>
              </a:rPr>
              <a:t>&lt;footer&gt;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678720" y="5590800"/>
            <a:ext cx="1877760" cy="40500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  <a:defRPr b="0" lang="en-US" sz="1300" spc="-1" strike="noStrike">
                <a:solidFill>
                  <a:srgbClr val="ffffff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fld id="{24E62870-091D-4E92-A4CA-209D90D6BA72}" type="slidenum">
              <a:rPr b="0" lang="en-US" sz="1300" spc="-1" strike="noStrike">
                <a:solidFill>
                  <a:srgbClr val="ffffff"/>
                </a:solidFill>
                <a:latin typeface="Arial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84040" y="2251080"/>
            <a:ext cx="701280" cy="419040"/>
            <a:chOff x="284040" y="2251080"/>
            <a:chExt cx="701280" cy="419040"/>
          </a:xfrm>
        </p:grpSpPr>
        <p:sp>
          <p:nvSpPr>
            <p:cNvPr id="42" name=""/>
            <p:cNvSpPr/>
            <p:nvPr/>
          </p:nvSpPr>
          <p:spPr>
            <a:xfrm>
              <a:off x="284040" y="2251080"/>
              <a:ext cx="431640" cy="419040"/>
            </a:xfrm>
            <a:prstGeom prst="rect">
              <a:avLst/>
            </a:prstGeom>
            <a:solidFill>
              <a:srgbClr val="ff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661680" y="2251080"/>
              <a:ext cx="323640" cy="419040"/>
            </a:xfrm>
            <a:prstGeom prst="rect">
              <a:avLst/>
            </a:prstGeom>
            <a:gradFill rotWithShape="0">
              <a:gsLst>
                <a:gs pos="0">
                  <a:srgbClr val="0000cc"/>
                </a:gs>
                <a:gs pos="100000">
                  <a:srgbClr val="ffcc00"/>
                </a:gs>
              </a:gsLst>
              <a:lin ang="10800000"/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</p:grpSp>
      <p:grpSp>
        <p:nvGrpSpPr>
          <p:cNvPr id="44" name=""/>
          <p:cNvGrpSpPr/>
          <p:nvPr/>
        </p:nvGrpSpPr>
        <p:grpSpPr>
          <a:xfrm>
            <a:off x="407880" y="2624040"/>
            <a:ext cx="725400" cy="419040"/>
            <a:chOff x="407880" y="2624040"/>
            <a:chExt cx="725400" cy="419040"/>
          </a:xfrm>
        </p:grpSpPr>
        <p:sp>
          <p:nvSpPr>
            <p:cNvPr id="45" name=""/>
            <p:cNvSpPr/>
            <p:nvPr/>
          </p:nvSpPr>
          <p:spPr>
            <a:xfrm>
              <a:off x="407880" y="2624040"/>
              <a:ext cx="414720" cy="419040"/>
            </a:xfrm>
            <a:prstGeom prst="rect">
              <a:avLst/>
            </a:prstGeom>
            <a:solidFill>
              <a:srgbClr val="99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770400" y="2624040"/>
              <a:ext cx="362880" cy="419040"/>
            </a:xfrm>
            <a:prstGeom prst="rect">
              <a:avLst/>
            </a:prstGeom>
            <a:gradFill rotWithShape="0">
              <a:gsLst>
                <a:gs pos="0">
                  <a:srgbClr val="0000cc"/>
                </a:gs>
                <a:gs pos="100000">
                  <a:srgbClr val="9900ff"/>
                </a:gs>
              </a:gsLst>
              <a:lin ang="10800000"/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</p:grpSp>
      <p:sp>
        <p:nvSpPr>
          <p:cNvPr id="47" name=""/>
          <p:cNvSpPr/>
          <p:nvPr/>
        </p:nvSpPr>
        <p:spPr>
          <a:xfrm>
            <a:off x="0" y="2558880"/>
            <a:ext cx="552600" cy="374760"/>
          </a:xfrm>
          <a:prstGeom prst="rect">
            <a:avLst/>
          </a:prstGeom>
          <a:gradFill rotWithShape="0">
            <a:gsLst>
              <a:gs pos="0">
                <a:srgbClr val="ff3399"/>
              </a:gs>
              <a:gs pos="100000">
                <a:srgbClr val="0000cc"/>
              </a:gs>
            </a:gsLst>
            <a:lin ang="81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>
            <a:off x="625320" y="2155680"/>
            <a:ext cx="30240" cy="930600"/>
          </a:xfrm>
          <a:prstGeom prst="rect">
            <a:avLst/>
          </a:prstGeom>
          <a:solidFill>
            <a:srgbClr val="000094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9" name="PlaceHolder 1"/>
          <p:cNvSpPr>
            <a:spLocks noGrp="1"/>
          </p:cNvSpPr>
          <p:nvPr>
            <p:ph type="title"/>
          </p:nvPr>
        </p:nvSpPr>
        <p:spPr>
          <a:xfrm>
            <a:off x="976320" y="1615680"/>
            <a:ext cx="7656480" cy="101124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b">
            <a:noAutofit/>
          </a:bodyPr>
          <a:p>
            <a:pPr indent="0" algn="ctr">
              <a:buNone/>
              <a:tabLst>
                <a:tab algn="l" pos="0"/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r>
              <a:rPr b="1" lang="en-US" sz="4000" spc="-1" strike="noStrike">
                <a:solidFill>
                  <a:srgbClr val="ffea18"/>
                </a:solidFill>
                <a:latin typeface="Arial"/>
              </a:rPr>
              <a:t>Click to edit the title text format</a:t>
            </a:r>
            <a:endParaRPr b="1" lang="en-US" sz="4000" spc="-1" strike="noStrike">
              <a:solidFill>
                <a:srgbClr val="ffea18"/>
              </a:solidFill>
              <a:latin typeface="Arial"/>
            </a:endParaRPr>
          </a:p>
        </p:txBody>
      </p:sp>
      <p:sp>
        <p:nvSpPr>
          <p:cNvPr id="50" name="PlaceHolder 2"/>
          <p:cNvSpPr>
            <a:spLocks noGrp="1"/>
          </p:cNvSpPr>
          <p:nvPr>
            <p:ph type="dt" idx="4"/>
          </p:nvPr>
        </p:nvSpPr>
        <p:spPr>
          <a:xfrm>
            <a:off x="976320" y="5524560"/>
            <a:ext cx="1874880" cy="40320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b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  <a:defRPr b="0" lang="en-US" sz="1300" spc="-1" strike="noStrike">
                <a:solidFill>
                  <a:srgbClr val="000094"/>
                </a:solidFill>
                <a:latin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r>
              <a:rPr b="0" lang="en-US" sz="1300" spc="-1" strike="noStrike">
                <a:solidFill>
                  <a:srgbClr val="000094"/>
                </a:solidFill>
                <a:latin typeface="Arial"/>
              </a:rPr>
              <a:t>&lt;date/time&gt;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PlaceHolder 3"/>
          <p:cNvSpPr>
            <a:spLocks noGrp="1"/>
          </p:cNvSpPr>
          <p:nvPr>
            <p:ph type="ftr" idx="5"/>
          </p:nvPr>
        </p:nvSpPr>
        <p:spPr>
          <a:xfrm>
            <a:off x="3378240" y="5524560"/>
            <a:ext cx="2851200" cy="40320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b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  <a:defRPr b="0" lang="en-US" sz="1300" spc="-1" strike="noStrike">
                <a:solidFill>
                  <a:srgbClr val="000094"/>
                </a:solidFill>
                <a:latin typeface="Arial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r>
              <a:rPr b="0" lang="en-US" sz="1300" spc="-1" strike="noStrike">
                <a:solidFill>
                  <a:srgbClr val="000094"/>
                </a:solidFill>
                <a:latin typeface="Arial"/>
              </a:rPr>
              <a:t>&lt;footer&gt;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PlaceHolder 4"/>
          <p:cNvSpPr>
            <a:spLocks noGrp="1"/>
          </p:cNvSpPr>
          <p:nvPr>
            <p:ph type="sldNum" idx="6"/>
          </p:nvPr>
        </p:nvSpPr>
        <p:spPr>
          <a:xfrm>
            <a:off x="6756480" y="5524560"/>
            <a:ext cx="1876320" cy="403200"/>
          </a:xfrm>
          <a:prstGeom prst="rect">
            <a:avLst/>
          </a:prstGeom>
          <a:noFill/>
          <a:ln w="0">
            <a:noFill/>
          </a:ln>
        </p:spPr>
        <p:txBody>
          <a:bodyPr lIns="84600" rIns="84600" tIns="42480" bIns="4248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  <a:defRPr b="0" lang="en-US" sz="1300" spc="-1" strike="noStrike">
                <a:solidFill>
                  <a:srgbClr val="000094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fld id="{2AE65FC7-4B56-4830-90F7-63DB48FD5757}" type="slidenum">
              <a:rPr b="0" lang="en-US" sz="1300" spc="-1" strike="noStrike">
                <a:solidFill>
                  <a:srgbClr val="000094"/>
                </a:solidFill>
                <a:latin typeface="Arial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 flipV="1">
            <a:off x="311040" y="2885040"/>
            <a:ext cx="8555040" cy="41400"/>
          </a:xfrm>
          <a:prstGeom prst="rect">
            <a:avLst/>
          </a:prstGeom>
          <a:gradFill rotWithShape="0">
            <a:gsLst>
              <a:gs pos="0">
                <a:srgbClr val="0000cc"/>
              </a:gs>
              <a:gs pos="100000">
                <a:srgbClr val="000094"/>
              </a:gs>
            </a:gsLst>
            <a:lin ang="108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84600" rIns="84600" tIns="-1080" bIns="-1080" anchor="ctr" rot="10800000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5" Type="http://schemas.openxmlformats.org/officeDocument/2006/relationships/image" Target="../media/image2.png"/><Relationship Id="rId6" Type="http://schemas.openxmlformats.org/officeDocument/2006/relationships/image" Target="../media/image2.png"/><Relationship Id="rId7" Type="http://schemas.openxmlformats.org/officeDocument/2006/relationships/slideLayout" Target="../slideLayouts/slideLayout5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0" name=""/>
          <p:cNvGrpSpPr/>
          <p:nvPr/>
        </p:nvGrpSpPr>
        <p:grpSpPr>
          <a:xfrm>
            <a:off x="0" y="0"/>
            <a:ext cx="9004320" cy="6065280"/>
            <a:chOff x="0" y="0"/>
            <a:chExt cx="9004320" cy="6065280"/>
          </a:xfrm>
        </p:grpSpPr>
        <p:grpSp>
          <p:nvGrpSpPr>
            <p:cNvPr id="91" name=""/>
            <p:cNvGrpSpPr/>
            <p:nvPr/>
          </p:nvGrpSpPr>
          <p:grpSpPr>
            <a:xfrm>
              <a:off x="0" y="0"/>
              <a:ext cx="4584960" cy="6065280"/>
              <a:chOff x="0" y="0"/>
              <a:chExt cx="4584960" cy="6065280"/>
            </a:xfrm>
          </p:grpSpPr>
          <p:sp>
            <p:nvSpPr>
              <p:cNvPr id="92" name=""/>
              <p:cNvSpPr/>
              <p:nvPr/>
            </p:nvSpPr>
            <p:spPr>
              <a:xfrm>
                <a:off x="364320" y="509400"/>
                <a:ext cx="400320" cy="456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5000" bIns="450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00000"/>
                    <a:tab algn="l" pos="1800360"/>
                    <a:tab algn="l" pos="2700360"/>
                    <a:tab algn="l" pos="3600360"/>
                    <a:tab algn="l" pos="4500720"/>
                    <a:tab algn="l" pos="5400720"/>
                    <a:tab algn="l" pos="6300720"/>
                    <a:tab algn="l" pos="7201080"/>
                    <a:tab algn="l" pos="8101080"/>
                    <a:tab algn="l" pos="9001080"/>
                    <a:tab algn="l" pos="9901080"/>
                    <a:tab algn="l" pos="10801440"/>
                  </a:tabLst>
                </a:pPr>
                <a:r>
                  <a:rPr b="1" lang="en-US" sz="2400" spc="-1" strike="noStrike">
                    <a:solidFill>
                      <a:srgbClr val="000000"/>
                    </a:solidFill>
                    <a:latin typeface="Arial"/>
                  </a:rPr>
                  <a:t>A</a:t>
                </a:r>
                <a:endParaRPr b="0" lang="en-US" sz="2400" spc="-1" strike="noStrike">
                  <a:solidFill>
                    <a:srgbClr val="ffffff"/>
                  </a:solidFill>
                  <a:latin typeface="Times New Roman"/>
                </a:endParaRPr>
              </a:p>
            </p:txBody>
          </p:sp>
          <p:grpSp>
            <p:nvGrpSpPr>
              <p:cNvPr id="93" name=""/>
              <p:cNvGrpSpPr/>
              <p:nvPr/>
            </p:nvGrpSpPr>
            <p:grpSpPr>
              <a:xfrm>
                <a:off x="0" y="0"/>
                <a:ext cx="4584960" cy="6065280"/>
                <a:chOff x="0" y="0"/>
                <a:chExt cx="4584960" cy="6065280"/>
              </a:xfrm>
            </p:grpSpPr>
            <p:sp>
              <p:nvSpPr>
                <p:cNvPr id="94" name=""/>
                <p:cNvSpPr/>
                <p:nvPr/>
              </p:nvSpPr>
              <p:spPr>
                <a:xfrm>
                  <a:off x="1041480" y="527040"/>
                  <a:ext cx="836280" cy="395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5000" bIns="450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2000" spc="-1" strike="noStrike">
                      <a:solidFill>
                        <a:srgbClr val="000000"/>
                      </a:solidFill>
                      <a:latin typeface="Arial"/>
                    </a:rPr>
                    <a:t>TNF</a:t>
                  </a:r>
                  <a:r>
                    <a:rPr b="1" lang="en-US" sz="20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</a:t>
                  </a:r>
                  <a:endParaRPr b="0" lang="en-US" sz="20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95" name=""/>
                <p:cNvSpPr/>
                <p:nvPr/>
              </p:nvSpPr>
              <p:spPr>
                <a:xfrm rot="16200000">
                  <a:off x="-1016280" y="2929320"/>
                  <a:ext cx="2307960" cy="2746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1" lang="en-US" sz="1800" spc="-1" strike="noStrike">
                      <a:solidFill>
                        <a:srgbClr val="000000"/>
                      </a:solidFill>
                      <a:latin typeface="Arial"/>
                    </a:rPr>
                    <a:t>pg / 5x10 </a:t>
                  </a:r>
                  <a:r>
                    <a:rPr b="1" lang="en-US" sz="1800" spc="-1" strike="noStrike" baseline="30000">
                      <a:solidFill>
                        <a:srgbClr val="000000"/>
                      </a:solidFill>
                      <a:latin typeface="Arial"/>
                    </a:rPr>
                    <a:t>5</a:t>
                  </a:r>
                  <a:r>
                    <a:rPr b="1" lang="en-US" sz="1800" spc="-1" strike="noStrike">
                      <a:solidFill>
                        <a:srgbClr val="000000"/>
                      </a:solidFill>
                      <a:latin typeface="Arial"/>
                    </a:rPr>
                    <a:t> cells/ml</a:t>
                  </a:r>
                  <a:endParaRPr b="0" lang="en-US" sz="18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96" name=""/>
                <p:cNvSpPr/>
                <p:nvPr/>
              </p:nvSpPr>
              <p:spPr>
                <a:xfrm>
                  <a:off x="1150920" y="3770280"/>
                  <a:ext cx="341280" cy="120600"/>
                </a:xfrm>
                <a:prstGeom prst="rect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97" name=""/>
                <p:cNvSpPr/>
                <p:nvPr/>
              </p:nvSpPr>
              <p:spPr>
                <a:xfrm>
                  <a:off x="2867040" y="3797280"/>
                  <a:ext cx="341280" cy="936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98" name=""/>
                <p:cNvSpPr/>
                <p:nvPr/>
              </p:nvSpPr>
              <p:spPr>
                <a:xfrm>
                  <a:off x="3724200" y="3247920"/>
                  <a:ext cx="339840" cy="642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99" name=""/>
                <p:cNvSpPr/>
                <p:nvPr/>
              </p:nvSpPr>
              <p:spPr>
                <a:xfrm>
                  <a:off x="1152720" y="3771720"/>
                  <a:ext cx="341280" cy="122400"/>
                </a:xfrm>
                <a:prstGeom prst="rect">
                  <a:avLst/>
                </a:prstGeom>
                <a:solidFill>
                  <a:srgbClr val="ffffff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00" name=""/>
                <p:cNvSpPr/>
                <p:nvPr/>
              </p:nvSpPr>
              <p:spPr>
                <a:xfrm flipV="1">
                  <a:off x="1319400" y="3727080"/>
                  <a:ext cx="1440" cy="442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20" bIns="-252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01" name=""/>
                <p:cNvSpPr/>
                <p:nvPr/>
              </p:nvSpPr>
              <p:spPr>
                <a:xfrm>
                  <a:off x="1303200" y="3727440"/>
                  <a:ext cx="3492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02" name=""/>
                <p:cNvSpPr/>
                <p:nvPr/>
              </p:nvSpPr>
              <p:spPr>
                <a:xfrm>
                  <a:off x="2009880" y="3146400"/>
                  <a:ext cx="342720" cy="745920"/>
                </a:xfrm>
                <a:prstGeom prst="rect">
                  <a:avLst/>
                </a:prstGeom>
                <a:solidFill>
                  <a:srgbClr val="c0c0c0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03" name=""/>
                <p:cNvSpPr/>
                <p:nvPr/>
              </p:nvSpPr>
              <p:spPr>
                <a:xfrm flipV="1">
                  <a:off x="2178000" y="3013200"/>
                  <a:ext cx="0" cy="1317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04" name=""/>
                <p:cNvSpPr/>
                <p:nvPr/>
              </p:nvSpPr>
              <p:spPr>
                <a:xfrm>
                  <a:off x="2158920" y="3013200"/>
                  <a:ext cx="3816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05" name=""/>
                <p:cNvSpPr/>
                <p:nvPr/>
              </p:nvSpPr>
              <p:spPr>
                <a:xfrm>
                  <a:off x="2871720" y="3798720"/>
                  <a:ext cx="339840" cy="93600"/>
                </a:xfrm>
                <a:prstGeom prst="rect">
                  <a:avLst/>
                </a:prstGeom>
                <a:solidFill>
                  <a:srgbClr val="01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06" name=""/>
                <p:cNvSpPr/>
                <p:nvPr/>
              </p:nvSpPr>
              <p:spPr>
                <a:xfrm flipV="1">
                  <a:off x="3036960" y="3774960"/>
                  <a:ext cx="1440" cy="223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07" name=""/>
                <p:cNvSpPr/>
                <p:nvPr/>
              </p:nvSpPr>
              <p:spPr>
                <a:xfrm>
                  <a:off x="3019320" y="3773520"/>
                  <a:ext cx="3672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08" name=""/>
                <p:cNvSpPr/>
                <p:nvPr/>
              </p:nvSpPr>
              <p:spPr>
                <a:xfrm>
                  <a:off x="3727440" y="3249720"/>
                  <a:ext cx="341280" cy="642600"/>
                </a:xfrm>
                <a:prstGeom prst="rect">
                  <a:avLst/>
                </a:prstGeom>
                <a:blipFill rotWithShape="0">
                  <a:blip r:embed="rId1"/>
                  <a:srcRect/>
                  <a:tile tx="0" ty="0" sx="100000" sy="100000" algn="ctr"/>
                </a:blip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09" name=""/>
                <p:cNvSpPr/>
                <p:nvPr/>
              </p:nvSpPr>
              <p:spPr>
                <a:xfrm flipV="1">
                  <a:off x="3894120" y="3106800"/>
                  <a:ext cx="1800" cy="1411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10" name=""/>
                <p:cNvSpPr/>
                <p:nvPr/>
              </p:nvSpPr>
              <p:spPr>
                <a:xfrm>
                  <a:off x="3875040" y="3106800"/>
                  <a:ext cx="3816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11" name=""/>
                <p:cNvSpPr/>
                <p:nvPr/>
              </p:nvSpPr>
              <p:spPr>
                <a:xfrm>
                  <a:off x="895320" y="2859120"/>
                  <a:ext cx="0" cy="10332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12" name=""/>
                <p:cNvSpPr/>
                <p:nvPr/>
              </p:nvSpPr>
              <p:spPr>
                <a:xfrm>
                  <a:off x="876240" y="3892320"/>
                  <a:ext cx="190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13" name=""/>
                <p:cNvSpPr/>
                <p:nvPr/>
              </p:nvSpPr>
              <p:spPr>
                <a:xfrm>
                  <a:off x="876240" y="3743280"/>
                  <a:ext cx="19080" cy="14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14" name=""/>
                <p:cNvSpPr/>
                <p:nvPr/>
              </p:nvSpPr>
              <p:spPr>
                <a:xfrm>
                  <a:off x="876240" y="3595680"/>
                  <a:ext cx="19080" cy="14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15" name=""/>
                <p:cNvSpPr/>
                <p:nvPr/>
              </p:nvSpPr>
              <p:spPr>
                <a:xfrm>
                  <a:off x="876240" y="3448080"/>
                  <a:ext cx="19080" cy="14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16" name=""/>
                <p:cNvSpPr/>
                <p:nvPr/>
              </p:nvSpPr>
              <p:spPr>
                <a:xfrm>
                  <a:off x="876240" y="3301920"/>
                  <a:ext cx="19080" cy="14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17" name=""/>
                <p:cNvSpPr/>
                <p:nvPr/>
              </p:nvSpPr>
              <p:spPr>
                <a:xfrm>
                  <a:off x="876240" y="3154320"/>
                  <a:ext cx="19080" cy="14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18" name=""/>
                <p:cNvSpPr/>
                <p:nvPr/>
              </p:nvSpPr>
              <p:spPr>
                <a:xfrm>
                  <a:off x="876240" y="3008160"/>
                  <a:ext cx="190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19" name=""/>
                <p:cNvSpPr/>
                <p:nvPr/>
              </p:nvSpPr>
              <p:spPr>
                <a:xfrm>
                  <a:off x="876240" y="2859120"/>
                  <a:ext cx="190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20" name=""/>
                <p:cNvSpPr/>
                <p:nvPr/>
              </p:nvSpPr>
              <p:spPr>
                <a:xfrm>
                  <a:off x="895320" y="3892320"/>
                  <a:ext cx="343224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21" name=""/>
                <p:cNvSpPr/>
                <p:nvPr/>
              </p:nvSpPr>
              <p:spPr>
                <a:xfrm flipV="1">
                  <a:off x="895320" y="3891960"/>
                  <a:ext cx="0" cy="97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7080" bIns="-3708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22" name=""/>
                <p:cNvSpPr/>
                <p:nvPr/>
              </p:nvSpPr>
              <p:spPr>
                <a:xfrm flipV="1">
                  <a:off x="1754280" y="3891960"/>
                  <a:ext cx="0" cy="97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7080" bIns="-3708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23" name=""/>
                <p:cNvSpPr/>
                <p:nvPr/>
              </p:nvSpPr>
              <p:spPr>
                <a:xfrm flipV="1">
                  <a:off x="2612880" y="3891960"/>
                  <a:ext cx="0" cy="97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7080" bIns="-3708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24" name=""/>
                <p:cNvSpPr/>
                <p:nvPr/>
              </p:nvSpPr>
              <p:spPr>
                <a:xfrm flipV="1">
                  <a:off x="3467160" y="3891960"/>
                  <a:ext cx="4680" cy="97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7080" bIns="-3708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25" name=""/>
                <p:cNvSpPr/>
                <p:nvPr/>
              </p:nvSpPr>
              <p:spPr>
                <a:xfrm flipV="1">
                  <a:off x="4327560" y="3891960"/>
                  <a:ext cx="1440" cy="9720"/>
                </a:xfrm>
                <a:prstGeom prst="line">
                  <a:avLst/>
                </a:prstGeom>
                <a:ln w="32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7080" bIns="-3708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26" name=""/>
                <p:cNvSpPr/>
                <p:nvPr/>
              </p:nvSpPr>
              <p:spPr>
                <a:xfrm>
                  <a:off x="735840" y="3833640"/>
                  <a:ext cx="8604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12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27" name=""/>
                <p:cNvSpPr/>
                <p:nvPr/>
              </p:nvSpPr>
              <p:spPr>
                <a:xfrm>
                  <a:off x="396720" y="3684600"/>
                  <a:ext cx="42732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20000</a:t>
                  </a:r>
                  <a:endParaRPr b="0" lang="en-US" sz="12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28" name=""/>
                <p:cNvSpPr/>
                <p:nvPr/>
              </p:nvSpPr>
              <p:spPr>
                <a:xfrm>
                  <a:off x="396720" y="3540240"/>
                  <a:ext cx="42732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40000</a:t>
                  </a:r>
                  <a:endParaRPr b="0" lang="en-US" sz="12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29" name=""/>
                <p:cNvSpPr/>
                <p:nvPr/>
              </p:nvSpPr>
              <p:spPr>
                <a:xfrm>
                  <a:off x="396720" y="3387600"/>
                  <a:ext cx="42732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60000</a:t>
                  </a:r>
                  <a:endParaRPr b="0" lang="en-US" sz="12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30" name=""/>
                <p:cNvSpPr/>
                <p:nvPr/>
              </p:nvSpPr>
              <p:spPr>
                <a:xfrm>
                  <a:off x="396720" y="3246480"/>
                  <a:ext cx="42732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80000</a:t>
                  </a:r>
                  <a:endParaRPr b="0" lang="en-US" sz="12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31" name=""/>
                <p:cNvSpPr/>
                <p:nvPr/>
              </p:nvSpPr>
              <p:spPr>
                <a:xfrm>
                  <a:off x="312120" y="3098880"/>
                  <a:ext cx="51264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100000</a:t>
                  </a:r>
                  <a:endParaRPr b="0" lang="en-US" sz="12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32" name=""/>
                <p:cNvSpPr/>
                <p:nvPr/>
              </p:nvSpPr>
              <p:spPr>
                <a:xfrm>
                  <a:off x="312120" y="2948040"/>
                  <a:ext cx="51264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120000</a:t>
                  </a:r>
                  <a:endParaRPr b="0" lang="en-US" sz="12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33" name=""/>
                <p:cNvSpPr/>
                <p:nvPr/>
              </p:nvSpPr>
              <p:spPr>
                <a:xfrm>
                  <a:off x="312120" y="2800440"/>
                  <a:ext cx="51264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140000</a:t>
                  </a:r>
                  <a:endParaRPr b="0" lang="en-US" sz="12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34" name=""/>
                <p:cNvSpPr/>
                <p:nvPr/>
              </p:nvSpPr>
              <p:spPr>
                <a:xfrm>
                  <a:off x="2184120" y="2452680"/>
                  <a:ext cx="2259720" cy="530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5000" bIns="450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i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P </a:t>
                  </a: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&lt; 0.0001 </a:t>
                  </a:r>
                  <a:r>
                    <a:rPr b="1" i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for NO</a:t>
                  </a:r>
                  <a:r>
                    <a:rPr b="1" lang="en-US" sz="1400" spc="-1" strike="noStrike" baseline="50000">
                      <a:solidFill>
                        <a:srgbClr val="000000"/>
                      </a:solidFill>
                      <a:latin typeface="Arial"/>
                    </a:rPr>
                    <a:t>.</a:t>
                  </a: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 effect</a:t>
                  </a:r>
                  <a:endParaRPr b="0" lang="en-US" sz="1400" spc="-1" strike="noStrike">
                    <a:solidFill>
                      <a:srgbClr val="ffffff"/>
                    </a:solidFill>
                    <a:latin typeface="Times New Roman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i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P </a:t>
                  </a: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= 0.34</a:t>
                  </a:r>
                  <a:r>
                    <a:rPr b="1" i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 for cAMP effect</a:t>
                  </a:r>
                  <a:endParaRPr b="0" lang="en-US" sz="1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35" name=""/>
                <p:cNvSpPr/>
                <p:nvPr/>
              </p:nvSpPr>
              <p:spPr>
                <a:xfrm>
                  <a:off x="1128600" y="1782720"/>
                  <a:ext cx="344520" cy="290520"/>
                </a:xfrm>
                <a:prstGeom prst="rect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36" name=""/>
                <p:cNvSpPr/>
                <p:nvPr/>
              </p:nvSpPr>
              <p:spPr>
                <a:xfrm>
                  <a:off x="2838600" y="1963800"/>
                  <a:ext cx="342720" cy="109440"/>
                </a:xfrm>
                <a:prstGeom prst="rect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37" name=""/>
                <p:cNvSpPr/>
                <p:nvPr/>
              </p:nvSpPr>
              <p:spPr>
                <a:xfrm>
                  <a:off x="3692520" y="1766880"/>
                  <a:ext cx="343080" cy="306360"/>
                </a:xfrm>
                <a:prstGeom prst="rect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grpSp>
              <p:nvGrpSpPr>
                <p:cNvPr id="138" name=""/>
                <p:cNvGrpSpPr/>
                <p:nvPr/>
              </p:nvGrpSpPr>
              <p:grpSpPr>
                <a:xfrm>
                  <a:off x="1131840" y="1728720"/>
                  <a:ext cx="344520" cy="345960"/>
                  <a:chOff x="1131840" y="1728720"/>
                  <a:chExt cx="344520" cy="345960"/>
                </a:xfrm>
              </p:grpSpPr>
              <p:sp>
                <p:nvSpPr>
                  <p:cNvPr id="139" name=""/>
                  <p:cNvSpPr/>
                  <p:nvPr/>
                </p:nvSpPr>
                <p:spPr>
                  <a:xfrm>
                    <a:off x="1131840" y="1784520"/>
                    <a:ext cx="344520" cy="290160"/>
                  </a:xfrm>
                  <a:prstGeom prst="rect">
                    <a:avLst/>
                  </a:prstGeom>
                  <a:solidFill>
                    <a:srgbClr val="ffffff"/>
                  </a:solidFill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400" spc="-1" strike="noStrike">
                      <a:solidFill>
                        <a:srgbClr val="ffffff"/>
                      </a:solidFill>
                      <a:latin typeface="Times New Roman"/>
                    </a:endParaRPr>
                  </a:p>
                </p:txBody>
              </p:sp>
              <p:sp>
                <p:nvSpPr>
                  <p:cNvPr id="140" name=""/>
                  <p:cNvSpPr/>
                  <p:nvPr/>
                </p:nvSpPr>
                <p:spPr>
                  <a:xfrm flipV="1">
                    <a:off x="1300680" y="1728720"/>
                    <a:ext cx="0" cy="5400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7200" bIns="7200" anchor="t">
                    <a:noAutofit/>
                  </a:bodyPr>
                  <a:p>
                    <a:endParaRPr b="0" lang="en-US" sz="2400" spc="-1" strike="noStrike">
                      <a:solidFill>
                        <a:srgbClr val="ffffff"/>
                      </a:solidFill>
                      <a:latin typeface="Times New Roman"/>
                    </a:endParaRPr>
                  </a:p>
                </p:txBody>
              </p:sp>
              <p:sp>
                <p:nvSpPr>
                  <p:cNvPr id="141" name=""/>
                  <p:cNvSpPr/>
                  <p:nvPr/>
                </p:nvSpPr>
                <p:spPr>
                  <a:xfrm>
                    <a:off x="1281960" y="1728720"/>
                    <a:ext cx="36720" cy="36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440" bIns="-46440" anchor="t">
                    <a:noAutofit/>
                  </a:bodyPr>
                  <a:p>
                    <a:endParaRPr b="0" lang="en-US" sz="2400" spc="-1" strike="noStrike">
                      <a:solidFill>
                        <a:srgbClr val="ffffff"/>
                      </a:solidFill>
                      <a:latin typeface="Times New Roman"/>
                    </a:endParaRPr>
                  </a:p>
                </p:txBody>
              </p:sp>
            </p:grpSp>
            <p:grpSp>
              <p:nvGrpSpPr>
                <p:cNvPr id="142" name=""/>
                <p:cNvGrpSpPr/>
                <p:nvPr/>
              </p:nvGrpSpPr>
              <p:grpSpPr>
                <a:xfrm>
                  <a:off x="1987560" y="1140840"/>
                  <a:ext cx="341280" cy="937080"/>
                  <a:chOff x="1987560" y="1140840"/>
                  <a:chExt cx="341280" cy="937080"/>
                </a:xfrm>
              </p:grpSpPr>
              <p:sp>
                <p:nvSpPr>
                  <p:cNvPr id="143" name=""/>
                  <p:cNvSpPr/>
                  <p:nvPr/>
                </p:nvSpPr>
                <p:spPr>
                  <a:xfrm>
                    <a:off x="1987560" y="1290600"/>
                    <a:ext cx="341280" cy="787320"/>
                  </a:xfrm>
                  <a:prstGeom prst="rect">
                    <a:avLst/>
                  </a:prstGeom>
                  <a:solidFill>
                    <a:srgbClr val="c0c0c0"/>
                  </a:solidFill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400" spc="-1" strike="noStrike">
                      <a:solidFill>
                        <a:srgbClr val="ffffff"/>
                      </a:solidFill>
                      <a:latin typeface="Times New Roman"/>
                    </a:endParaRPr>
                  </a:p>
                </p:txBody>
              </p:sp>
              <p:sp>
                <p:nvSpPr>
                  <p:cNvPr id="144" name=""/>
                  <p:cNvSpPr/>
                  <p:nvPr/>
                </p:nvSpPr>
                <p:spPr>
                  <a:xfrm flipV="1">
                    <a:off x="2154240" y="1140840"/>
                    <a:ext cx="0" cy="14796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400" spc="-1" strike="noStrike">
                      <a:solidFill>
                        <a:srgbClr val="ffffff"/>
                      </a:solidFill>
                      <a:latin typeface="Times New Roman"/>
                    </a:endParaRPr>
                  </a:p>
                </p:txBody>
              </p:sp>
              <p:sp>
                <p:nvSpPr>
                  <p:cNvPr id="145" name=""/>
                  <p:cNvSpPr/>
                  <p:nvPr/>
                </p:nvSpPr>
                <p:spPr>
                  <a:xfrm>
                    <a:off x="2136960" y="1141200"/>
                    <a:ext cx="34920" cy="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2400" spc="-1" strike="noStrike">
                      <a:solidFill>
                        <a:srgbClr val="ffffff"/>
                      </a:solidFill>
                      <a:latin typeface="Times New Roman"/>
                    </a:endParaRPr>
                  </a:p>
                </p:txBody>
              </p:sp>
            </p:grpSp>
            <p:grpSp>
              <p:nvGrpSpPr>
                <p:cNvPr id="146" name=""/>
                <p:cNvGrpSpPr/>
                <p:nvPr/>
              </p:nvGrpSpPr>
              <p:grpSpPr>
                <a:xfrm>
                  <a:off x="3695760" y="1706400"/>
                  <a:ext cx="342720" cy="367920"/>
                  <a:chOff x="3695760" y="1706400"/>
                  <a:chExt cx="342720" cy="367920"/>
                </a:xfrm>
              </p:grpSpPr>
              <p:sp>
                <p:nvSpPr>
                  <p:cNvPr id="147" name=""/>
                  <p:cNvSpPr/>
                  <p:nvPr/>
                </p:nvSpPr>
                <p:spPr>
                  <a:xfrm>
                    <a:off x="3695760" y="1767600"/>
                    <a:ext cx="342720" cy="306720"/>
                  </a:xfrm>
                  <a:prstGeom prst="rect">
                    <a:avLst/>
                  </a:prstGeom>
                  <a:blipFill rotWithShape="0">
                    <a:blip r:embed="rId2"/>
                    <a:srcRect/>
                    <a:tile tx="0" ty="0" sx="100000" sy="100000" algn="ctr"/>
                  </a:blipFill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400" spc="-1" strike="noStrike">
                      <a:solidFill>
                        <a:srgbClr val="ffffff"/>
                      </a:solidFill>
                      <a:latin typeface="Times New Roman"/>
                    </a:endParaRPr>
                  </a:p>
                </p:txBody>
              </p:sp>
              <p:sp>
                <p:nvSpPr>
                  <p:cNvPr id="148" name=""/>
                  <p:cNvSpPr/>
                  <p:nvPr/>
                </p:nvSpPr>
                <p:spPr>
                  <a:xfrm flipV="1">
                    <a:off x="3864240" y="1706400"/>
                    <a:ext cx="1080" cy="6048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3680" bIns="13680" anchor="t">
                    <a:noAutofit/>
                  </a:bodyPr>
                  <a:p>
                    <a:endParaRPr b="0" lang="en-US" sz="2400" spc="-1" strike="noStrike">
                      <a:solidFill>
                        <a:srgbClr val="ffffff"/>
                      </a:solidFill>
                      <a:latin typeface="Times New Roman"/>
                    </a:endParaRPr>
                  </a:p>
                </p:txBody>
              </p:sp>
              <p:sp>
                <p:nvSpPr>
                  <p:cNvPr id="149" name=""/>
                  <p:cNvSpPr/>
                  <p:nvPr/>
                </p:nvSpPr>
                <p:spPr>
                  <a:xfrm>
                    <a:off x="3847320" y="1706400"/>
                    <a:ext cx="35280" cy="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2400" spc="-1" strike="noStrike">
                      <a:solidFill>
                        <a:srgbClr val="ffffff"/>
                      </a:solidFill>
                      <a:latin typeface="Times New Roman"/>
                    </a:endParaRPr>
                  </a:p>
                </p:txBody>
              </p:sp>
            </p:grpSp>
            <p:sp>
              <p:nvSpPr>
                <p:cNvPr id="150" name=""/>
                <p:cNvSpPr/>
                <p:nvPr/>
              </p:nvSpPr>
              <p:spPr>
                <a:xfrm>
                  <a:off x="876240" y="1058760"/>
                  <a:ext cx="0" cy="10159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51" name=""/>
                <p:cNvSpPr/>
                <p:nvPr/>
              </p:nvSpPr>
              <p:spPr>
                <a:xfrm>
                  <a:off x="857160" y="2074680"/>
                  <a:ext cx="190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52" name=""/>
                <p:cNvSpPr/>
                <p:nvPr/>
              </p:nvSpPr>
              <p:spPr>
                <a:xfrm>
                  <a:off x="857160" y="1973160"/>
                  <a:ext cx="190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53" name=""/>
                <p:cNvSpPr/>
                <p:nvPr/>
              </p:nvSpPr>
              <p:spPr>
                <a:xfrm>
                  <a:off x="857160" y="1871640"/>
                  <a:ext cx="19080" cy="14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54" name=""/>
                <p:cNvSpPr/>
                <p:nvPr/>
              </p:nvSpPr>
              <p:spPr>
                <a:xfrm>
                  <a:off x="857160" y="1770120"/>
                  <a:ext cx="190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55" name=""/>
                <p:cNvSpPr/>
                <p:nvPr/>
              </p:nvSpPr>
              <p:spPr>
                <a:xfrm>
                  <a:off x="857160" y="1668240"/>
                  <a:ext cx="190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56" name=""/>
                <p:cNvSpPr/>
                <p:nvPr/>
              </p:nvSpPr>
              <p:spPr>
                <a:xfrm>
                  <a:off x="857160" y="1566720"/>
                  <a:ext cx="190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57" name=""/>
                <p:cNvSpPr/>
                <p:nvPr/>
              </p:nvSpPr>
              <p:spPr>
                <a:xfrm>
                  <a:off x="857160" y="1465200"/>
                  <a:ext cx="190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58" name=""/>
                <p:cNvSpPr/>
                <p:nvPr/>
              </p:nvSpPr>
              <p:spPr>
                <a:xfrm>
                  <a:off x="857160" y="1365120"/>
                  <a:ext cx="190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59" name=""/>
                <p:cNvSpPr/>
                <p:nvPr/>
              </p:nvSpPr>
              <p:spPr>
                <a:xfrm>
                  <a:off x="857160" y="1262160"/>
                  <a:ext cx="190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60" name=""/>
                <p:cNvSpPr/>
                <p:nvPr/>
              </p:nvSpPr>
              <p:spPr>
                <a:xfrm>
                  <a:off x="857160" y="1160280"/>
                  <a:ext cx="190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61" name=""/>
                <p:cNvSpPr/>
                <p:nvPr/>
              </p:nvSpPr>
              <p:spPr>
                <a:xfrm>
                  <a:off x="857160" y="1058760"/>
                  <a:ext cx="190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62" name=""/>
                <p:cNvSpPr/>
                <p:nvPr/>
              </p:nvSpPr>
              <p:spPr>
                <a:xfrm>
                  <a:off x="876240" y="2074680"/>
                  <a:ext cx="341784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63" name=""/>
                <p:cNvSpPr/>
                <p:nvPr/>
              </p:nvSpPr>
              <p:spPr>
                <a:xfrm flipV="1">
                  <a:off x="876240" y="2074320"/>
                  <a:ext cx="0" cy="97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7080" bIns="-3708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64" name=""/>
                <p:cNvSpPr/>
                <p:nvPr/>
              </p:nvSpPr>
              <p:spPr>
                <a:xfrm flipV="1">
                  <a:off x="1731960" y="2074320"/>
                  <a:ext cx="0" cy="97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7080" bIns="-3708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65" name=""/>
                <p:cNvSpPr/>
                <p:nvPr/>
              </p:nvSpPr>
              <p:spPr>
                <a:xfrm flipV="1">
                  <a:off x="2585880" y="2074320"/>
                  <a:ext cx="0" cy="97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7080" bIns="-3708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66" name=""/>
                <p:cNvSpPr/>
                <p:nvPr/>
              </p:nvSpPr>
              <p:spPr>
                <a:xfrm flipV="1">
                  <a:off x="3441600" y="2074320"/>
                  <a:ext cx="0" cy="97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7080" bIns="-3708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67" name=""/>
                <p:cNvSpPr/>
                <p:nvPr/>
              </p:nvSpPr>
              <p:spPr>
                <a:xfrm flipV="1">
                  <a:off x="4294080" y="2074320"/>
                  <a:ext cx="0" cy="9720"/>
                </a:xfrm>
                <a:prstGeom prst="line">
                  <a:avLst/>
                </a:prstGeom>
                <a:ln w="32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7080" bIns="-3708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68" name=""/>
                <p:cNvSpPr/>
                <p:nvPr/>
              </p:nvSpPr>
              <p:spPr>
                <a:xfrm>
                  <a:off x="1117440" y="5637240"/>
                  <a:ext cx="386280" cy="213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GSH</a:t>
                  </a:r>
                  <a:endParaRPr b="0" lang="en-US" sz="1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69" name=""/>
                <p:cNvSpPr/>
                <p:nvPr/>
              </p:nvSpPr>
              <p:spPr>
                <a:xfrm>
                  <a:off x="1920600" y="5637240"/>
                  <a:ext cx="524880" cy="213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GSNO</a:t>
                  </a:r>
                  <a:endParaRPr b="0" lang="en-US" sz="1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70" name=""/>
                <p:cNvSpPr/>
                <p:nvPr/>
              </p:nvSpPr>
              <p:spPr>
                <a:xfrm>
                  <a:off x="2724120" y="5637240"/>
                  <a:ext cx="654120" cy="4266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GSH </a:t>
                  </a:r>
                  <a:endParaRPr b="0" lang="en-US" sz="1400" spc="-1" strike="noStrike">
                    <a:solidFill>
                      <a:srgbClr val="ffffff"/>
                    </a:solidFill>
                    <a:latin typeface="Times New Roman"/>
                  </a:endParaRPr>
                </a:p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cAMP</a:t>
                  </a:r>
                  <a:endParaRPr b="0" lang="en-US" sz="1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71" name=""/>
                <p:cNvSpPr/>
                <p:nvPr/>
              </p:nvSpPr>
              <p:spPr>
                <a:xfrm>
                  <a:off x="3661920" y="5638680"/>
                  <a:ext cx="524880" cy="4266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GSNO</a:t>
                  </a:r>
                  <a:endParaRPr b="0" lang="en-US" sz="1400" spc="-1" strike="noStrike">
                    <a:solidFill>
                      <a:srgbClr val="ffffff"/>
                    </a:solidFill>
                    <a:latin typeface="Times New Roman"/>
                  </a:endParaRPr>
                </a:p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cAMP</a:t>
                  </a:r>
                  <a:endParaRPr b="0" lang="en-US" sz="1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72" name=""/>
                <p:cNvSpPr/>
                <p:nvPr/>
              </p:nvSpPr>
              <p:spPr>
                <a:xfrm>
                  <a:off x="713520" y="2014560"/>
                  <a:ext cx="8604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12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73" name=""/>
                <p:cNvSpPr/>
                <p:nvPr/>
              </p:nvSpPr>
              <p:spPr>
                <a:xfrm>
                  <a:off x="628920" y="1824120"/>
                  <a:ext cx="17136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40</a:t>
                  </a:r>
                  <a:endParaRPr b="0" lang="en-US" sz="12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74" name=""/>
                <p:cNvSpPr/>
                <p:nvPr/>
              </p:nvSpPr>
              <p:spPr>
                <a:xfrm>
                  <a:off x="628920" y="1608120"/>
                  <a:ext cx="17136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80</a:t>
                  </a:r>
                  <a:endParaRPr b="0" lang="en-US" sz="12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75" name=""/>
                <p:cNvSpPr/>
                <p:nvPr/>
              </p:nvSpPr>
              <p:spPr>
                <a:xfrm>
                  <a:off x="543960" y="1404720"/>
                  <a:ext cx="25668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120</a:t>
                  </a:r>
                  <a:endParaRPr b="0" lang="en-US" sz="12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76" name=""/>
                <p:cNvSpPr/>
                <p:nvPr/>
              </p:nvSpPr>
              <p:spPr>
                <a:xfrm>
                  <a:off x="543960" y="1204920"/>
                  <a:ext cx="25668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160</a:t>
                  </a:r>
                  <a:endParaRPr b="0" lang="en-US" sz="12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77" name=""/>
                <p:cNvSpPr/>
                <p:nvPr/>
              </p:nvSpPr>
              <p:spPr>
                <a:xfrm>
                  <a:off x="543960" y="1027080"/>
                  <a:ext cx="25668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200</a:t>
                  </a:r>
                  <a:endParaRPr b="0" lang="en-US" sz="12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78" name=""/>
                <p:cNvSpPr/>
                <p:nvPr/>
              </p:nvSpPr>
              <p:spPr>
                <a:xfrm>
                  <a:off x="2127240" y="633240"/>
                  <a:ext cx="2457720" cy="530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5000" bIns="450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i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P </a:t>
                  </a: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&lt; 0.0001 </a:t>
                  </a:r>
                  <a:r>
                    <a:rPr b="1" i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for NO</a:t>
                  </a:r>
                  <a:r>
                    <a:rPr b="1" lang="en-US" sz="1400" spc="-1" strike="noStrike" baseline="50000">
                      <a:solidFill>
                        <a:srgbClr val="000000"/>
                      </a:solidFill>
                      <a:latin typeface="Arial"/>
                    </a:rPr>
                    <a:t>.</a:t>
                  </a: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 effect</a:t>
                  </a:r>
                  <a:endParaRPr b="0" lang="en-US" sz="1400" spc="-1" strike="noStrike">
                    <a:solidFill>
                      <a:srgbClr val="ffffff"/>
                    </a:solidFill>
                    <a:latin typeface="Times New Roman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i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P </a:t>
                  </a: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&lt; 0.0001  for cAMP effect</a:t>
                  </a:r>
                  <a:endParaRPr b="0" lang="en-US" sz="1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grpSp>
              <p:nvGrpSpPr>
                <p:cNvPr id="179" name=""/>
                <p:cNvGrpSpPr/>
                <p:nvPr/>
              </p:nvGrpSpPr>
              <p:grpSpPr>
                <a:xfrm>
                  <a:off x="2841480" y="1944720"/>
                  <a:ext cx="343080" cy="128160"/>
                  <a:chOff x="2841480" y="1944720"/>
                  <a:chExt cx="343080" cy="128160"/>
                </a:xfrm>
              </p:grpSpPr>
              <p:sp>
                <p:nvSpPr>
                  <p:cNvPr id="180" name=""/>
                  <p:cNvSpPr/>
                  <p:nvPr/>
                </p:nvSpPr>
                <p:spPr>
                  <a:xfrm flipV="1">
                    <a:off x="3009240" y="1944720"/>
                    <a:ext cx="0" cy="1872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8080" bIns="-28080" anchor="t">
                    <a:noAutofit/>
                  </a:bodyPr>
                  <a:p>
                    <a:endParaRPr b="0" lang="en-US" sz="2400" spc="-1" strike="noStrike">
                      <a:solidFill>
                        <a:srgbClr val="ffffff"/>
                      </a:solidFill>
                      <a:latin typeface="Times New Roman"/>
                    </a:endParaRPr>
                  </a:p>
                </p:txBody>
              </p:sp>
              <p:sp>
                <p:nvSpPr>
                  <p:cNvPr id="181" name=""/>
                  <p:cNvSpPr/>
                  <p:nvPr/>
                </p:nvSpPr>
                <p:spPr>
                  <a:xfrm>
                    <a:off x="2992320" y="1944720"/>
                    <a:ext cx="34920" cy="36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440" bIns="-46440" anchor="t">
                    <a:noAutofit/>
                  </a:bodyPr>
                  <a:p>
                    <a:endParaRPr b="0" lang="en-US" sz="2400" spc="-1" strike="noStrike">
                      <a:solidFill>
                        <a:srgbClr val="ffffff"/>
                      </a:solidFill>
                      <a:latin typeface="Times New Roman"/>
                    </a:endParaRPr>
                  </a:p>
                </p:txBody>
              </p:sp>
              <p:sp>
                <p:nvSpPr>
                  <p:cNvPr id="182" name=""/>
                  <p:cNvSpPr/>
                  <p:nvPr/>
                </p:nvSpPr>
                <p:spPr>
                  <a:xfrm>
                    <a:off x="2841480" y="1964880"/>
                    <a:ext cx="343080" cy="108000"/>
                  </a:xfrm>
                  <a:prstGeom prst="rect">
                    <a:avLst/>
                  </a:prstGeom>
                  <a:solidFill>
                    <a:srgbClr val="010000"/>
                  </a:solidFill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400" spc="-1" strike="noStrike">
                      <a:solidFill>
                        <a:srgbClr val="ffffff"/>
                      </a:solidFill>
                      <a:latin typeface="Times New Roman"/>
                    </a:endParaRPr>
                  </a:p>
                </p:txBody>
              </p:sp>
            </p:grpSp>
            <p:sp>
              <p:nvSpPr>
                <p:cNvPr id="183" name=""/>
                <p:cNvSpPr/>
                <p:nvPr/>
              </p:nvSpPr>
              <p:spPr>
                <a:xfrm>
                  <a:off x="892080" y="4456080"/>
                  <a:ext cx="3468960" cy="1055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84" name=""/>
                <p:cNvSpPr/>
                <p:nvPr/>
              </p:nvSpPr>
              <p:spPr>
                <a:xfrm>
                  <a:off x="1144440" y="5448240"/>
                  <a:ext cx="355680" cy="63360"/>
                </a:xfrm>
                <a:prstGeom prst="rect">
                  <a:avLst/>
                </a:prstGeom>
                <a:solidFill>
                  <a:srgbClr val="ffffff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6560" bIns="1656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85" name=""/>
                <p:cNvSpPr/>
                <p:nvPr/>
              </p:nvSpPr>
              <p:spPr>
                <a:xfrm>
                  <a:off x="2017800" y="5243400"/>
                  <a:ext cx="344520" cy="268200"/>
                </a:xfrm>
                <a:prstGeom prst="rect">
                  <a:avLst/>
                </a:prstGeom>
                <a:solidFill>
                  <a:srgbClr val="c0c0c0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86" name=""/>
                <p:cNvSpPr/>
                <p:nvPr/>
              </p:nvSpPr>
              <p:spPr>
                <a:xfrm>
                  <a:off x="2881440" y="5352840"/>
                  <a:ext cx="353880" cy="158760"/>
                </a:xfrm>
                <a:prstGeom prst="rect">
                  <a:avLst/>
                </a:prstGeom>
                <a:solidFill>
                  <a:srgbClr val="000000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87" name=""/>
                <p:cNvSpPr/>
                <p:nvPr/>
              </p:nvSpPr>
              <p:spPr>
                <a:xfrm>
                  <a:off x="3754440" y="4686120"/>
                  <a:ext cx="343080" cy="825480"/>
                </a:xfrm>
                <a:prstGeom prst="rect">
                  <a:avLst/>
                </a:prstGeom>
                <a:blipFill rotWithShape="0">
                  <a:blip r:embed="rId3"/>
                  <a:srcRect/>
                  <a:tile tx="0" ty="0" sx="100000" sy="100000" algn="ctr"/>
                </a:blip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88" name=""/>
                <p:cNvSpPr/>
                <p:nvPr/>
              </p:nvSpPr>
              <p:spPr>
                <a:xfrm flipV="1">
                  <a:off x="1317600" y="5440320"/>
                  <a:ext cx="1800" cy="79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880" bIns="-3888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89" name=""/>
                <p:cNvSpPr/>
                <p:nvPr/>
              </p:nvSpPr>
              <p:spPr>
                <a:xfrm>
                  <a:off x="1287360" y="5437080"/>
                  <a:ext cx="69840" cy="18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90" name=""/>
                <p:cNvSpPr/>
                <p:nvPr/>
              </p:nvSpPr>
              <p:spPr>
                <a:xfrm flipV="1">
                  <a:off x="2181240" y="5185800"/>
                  <a:ext cx="1440" cy="572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440" bIns="1044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91" name=""/>
                <p:cNvSpPr/>
                <p:nvPr/>
              </p:nvSpPr>
              <p:spPr>
                <a:xfrm>
                  <a:off x="2146320" y="5183280"/>
                  <a:ext cx="71280" cy="14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92" name=""/>
                <p:cNvSpPr/>
                <p:nvPr/>
              </p:nvSpPr>
              <p:spPr>
                <a:xfrm flipV="1">
                  <a:off x="3054240" y="5314680"/>
                  <a:ext cx="1800" cy="378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9000" bIns="-90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93" name=""/>
                <p:cNvSpPr/>
                <p:nvPr/>
              </p:nvSpPr>
              <p:spPr>
                <a:xfrm>
                  <a:off x="3022560" y="5315040"/>
                  <a:ext cx="69840" cy="14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94" name=""/>
                <p:cNvSpPr/>
                <p:nvPr/>
              </p:nvSpPr>
              <p:spPr>
                <a:xfrm flipV="1">
                  <a:off x="3924360" y="4519080"/>
                  <a:ext cx="1440" cy="1666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95" name=""/>
                <p:cNvSpPr/>
                <p:nvPr/>
              </p:nvSpPr>
              <p:spPr>
                <a:xfrm>
                  <a:off x="3892680" y="4511520"/>
                  <a:ext cx="69840" cy="18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96" name=""/>
                <p:cNvSpPr/>
                <p:nvPr/>
              </p:nvSpPr>
              <p:spPr>
                <a:xfrm>
                  <a:off x="892080" y="5511600"/>
                  <a:ext cx="3468960" cy="18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97" name=""/>
                <p:cNvSpPr/>
                <p:nvPr/>
              </p:nvSpPr>
              <p:spPr>
                <a:xfrm flipV="1">
                  <a:off x="1763640" y="5511600"/>
                  <a:ext cx="1800" cy="129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98" name=""/>
                <p:cNvSpPr/>
                <p:nvPr/>
              </p:nvSpPr>
              <p:spPr>
                <a:xfrm flipV="1">
                  <a:off x="2627280" y="5511600"/>
                  <a:ext cx="0" cy="129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199" name=""/>
                <p:cNvSpPr/>
                <p:nvPr/>
              </p:nvSpPr>
              <p:spPr>
                <a:xfrm flipV="1">
                  <a:off x="3498840" y="5511600"/>
                  <a:ext cx="1440" cy="129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00" name=""/>
                <p:cNvSpPr/>
                <p:nvPr/>
              </p:nvSpPr>
              <p:spPr>
                <a:xfrm flipV="1">
                  <a:off x="4361040" y="5511600"/>
                  <a:ext cx="1440" cy="12960"/>
                </a:xfrm>
                <a:prstGeom prst="line">
                  <a:avLst/>
                </a:prstGeom>
                <a:ln w="1116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01" name=""/>
                <p:cNvSpPr/>
                <p:nvPr/>
              </p:nvSpPr>
              <p:spPr>
                <a:xfrm>
                  <a:off x="737280" y="5422680"/>
                  <a:ext cx="8604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12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02" name=""/>
                <p:cNvSpPr/>
                <p:nvPr/>
              </p:nvSpPr>
              <p:spPr>
                <a:xfrm>
                  <a:off x="737280" y="5224320"/>
                  <a:ext cx="8604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4</a:t>
                  </a:r>
                  <a:endParaRPr b="0" lang="en-US" sz="12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03" name=""/>
                <p:cNvSpPr/>
                <p:nvPr/>
              </p:nvSpPr>
              <p:spPr>
                <a:xfrm>
                  <a:off x="737280" y="5022720"/>
                  <a:ext cx="8604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8</a:t>
                  </a:r>
                  <a:endParaRPr b="0" lang="en-US" sz="12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04" name=""/>
                <p:cNvSpPr/>
                <p:nvPr/>
              </p:nvSpPr>
              <p:spPr>
                <a:xfrm>
                  <a:off x="652680" y="4817880"/>
                  <a:ext cx="17136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12</a:t>
                  </a:r>
                  <a:endParaRPr b="0" lang="en-US" sz="12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05" name=""/>
                <p:cNvSpPr/>
                <p:nvPr/>
              </p:nvSpPr>
              <p:spPr>
                <a:xfrm>
                  <a:off x="2109960" y="4030560"/>
                  <a:ext cx="2358720" cy="530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5000" bIns="450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i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P </a:t>
                  </a: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&lt; 0.0001 </a:t>
                  </a:r>
                  <a:r>
                    <a:rPr b="1" i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for NO</a:t>
                  </a:r>
                  <a:r>
                    <a:rPr b="1" lang="en-US" sz="1400" spc="-1" strike="noStrike" baseline="50000">
                      <a:solidFill>
                        <a:srgbClr val="000000"/>
                      </a:solidFill>
                      <a:latin typeface="Arial"/>
                    </a:rPr>
                    <a:t>.</a:t>
                  </a: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 effect</a:t>
                  </a:r>
                  <a:r>
                    <a:rPr b="1" i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endParaRPr b="0" lang="en-US" sz="1400" spc="-1" strike="noStrike">
                    <a:solidFill>
                      <a:srgbClr val="ffffff"/>
                    </a:solidFill>
                    <a:latin typeface="Times New Roman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i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P </a:t>
                  </a: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= 0.003</a:t>
                  </a:r>
                  <a:r>
                    <a:rPr b="1" i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 for cAMP effect</a:t>
                  </a:r>
                  <a:endParaRPr b="0" lang="en-US" sz="1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06" name=""/>
                <p:cNvSpPr/>
                <p:nvPr/>
              </p:nvSpPr>
              <p:spPr>
                <a:xfrm>
                  <a:off x="889200" y="4502160"/>
                  <a:ext cx="0" cy="10159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07" name=""/>
                <p:cNvSpPr/>
                <p:nvPr/>
              </p:nvSpPr>
              <p:spPr>
                <a:xfrm>
                  <a:off x="873000" y="5511600"/>
                  <a:ext cx="190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08" name=""/>
                <p:cNvSpPr/>
                <p:nvPr/>
              </p:nvSpPr>
              <p:spPr>
                <a:xfrm>
                  <a:off x="873000" y="5403960"/>
                  <a:ext cx="190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09" name=""/>
                <p:cNvSpPr/>
                <p:nvPr/>
              </p:nvSpPr>
              <p:spPr>
                <a:xfrm>
                  <a:off x="873000" y="5302080"/>
                  <a:ext cx="19080" cy="18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10" name=""/>
                <p:cNvSpPr/>
                <p:nvPr/>
              </p:nvSpPr>
              <p:spPr>
                <a:xfrm>
                  <a:off x="873000" y="5200560"/>
                  <a:ext cx="190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11" name=""/>
                <p:cNvSpPr/>
                <p:nvPr/>
              </p:nvSpPr>
              <p:spPr>
                <a:xfrm>
                  <a:off x="873000" y="5099040"/>
                  <a:ext cx="190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12" name=""/>
                <p:cNvSpPr/>
                <p:nvPr/>
              </p:nvSpPr>
              <p:spPr>
                <a:xfrm>
                  <a:off x="873000" y="4997520"/>
                  <a:ext cx="190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13" name=""/>
                <p:cNvSpPr/>
                <p:nvPr/>
              </p:nvSpPr>
              <p:spPr>
                <a:xfrm>
                  <a:off x="873000" y="4895640"/>
                  <a:ext cx="190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14" name=""/>
                <p:cNvSpPr/>
                <p:nvPr/>
              </p:nvSpPr>
              <p:spPr>
                <a:xfrm>
                  <a:off x="873000" y="4795920"/>
                  <a:ext cx="190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15" name=""/>
                <p:cNvSpPr/>
                <p:nvPr/>
              </p:nvSpPr>
              <p:spPr>
                <a:xfrm>
                  <a:off x="873000" y="4692600"/>
                  <a:ext cx="190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16" name=""/>
                <p:cNvSpPr/>
                <p:nvPr/>
              </p:nvSpPr>
              <p:spPr>
                <a:xfrm>
                  <a:off x="873000" y="4591080"/>
                  <a:ext cx="19080" cy="14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17" name=""/>
                <p:cNvSpPr/>
                <p:nvPr/>
              </p:nvSpPr>
              <p:spPr>
                <a:xfrm>
                  <a:off x="873000" y="4508280"/>
                  <a:ext cx="190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18" name=""/>
                <p:cNvSpPr/>
                <p:nvPr/>
              </p:nvSpPr>
              <p:spPr>
                <a:xfrm flipV="1">
                  <a:off x="892080" y="5505480"/>
                  <a:ext cx="0" cy="93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7440" bIns="-3744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19" name=""/>
                <p:cNvSpPr/>
                <p:nvPr/>
              </p:nvSpPr>
              <p:spPr>
                <a:xfrm>
                  <a:off x="593640" y="4613400"/>
                  <a:ext cx="22860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t">
                  <a:spAutoFit/>
                </a:bodyPr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16</a:t>
                  </a:r>
                  <a:endParaRPr b="0" lang="en-US" sz="12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20" name=""/>
                <p:cNvSpPr/>
                <p:nvPr/>
              </p:nvSpPr>
              <p:spPr>
                <a:xfrm>
                  <a:off x="1040760" y="2233440"/>
                  <a:ext cx="633240" cy="395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5000" bIns="450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2000" spc="-1" strike="noStrike">
                      <a:solidFill>
                        <a:srgbClr val="000000"/>
                      </a:solidFill>
                      <a:latin typeface="Arial"/>
                    </a:rPr>
                    <a:t>IL-8</a:t>
                  </a:r>
                  <a:endParaRPr b="0" lang="en-US" sz="20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21" name=""/>
                <p:cNvSpPr/>
                <p:nvPr/>
              </p:nvSpPr>
              <p:spPr>
                <a:xfrm>
                  <a:off x="1040760" y="4087800"/>
                  <a:ext cx="773280" cy="395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5000" bIns="450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2000" spc="-1" strike="noStrike">
                      <a:solidFill>
                        <a:srgbClr val="000000"/>
                      </a:solidFill>
                      <a:latin typeface="Arial"/>
                    </a:rPr>
                    <a:t>IL-1</a:t>
                  </a:r>
                  <a:r>
                    <a:rPr b="1" lang="en-US" sz="20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</a:t>
                  </a:r>
                  <a:endParaRPr b="0" lang="en-US" sz="20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22" name=""/>
                <p:cNvSpPr/>
                <p:nvPr/>
              </p:nvSpPr>
              <p:spPr>
                <a:xfrm>
                  <a:off x="2016720" y="0"/>
                  <a:ext cx="1076760" cy="456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5000" bIns="450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2400" spc="-1" strike="noStrike">
                      <a:solidFill>
                        <a:srgbClr val="000000"/>
                      </a:solidFill>
                      <a:latin typeface="Arial"/>
                    </a:rPr>
                    <a:t>ELISA</a:t>
                  </a:r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</p:grpSp>
        </p:grpSp>
        <p:grpSp>
          <p:nvGrpSpPr>
            <p:cNvPr id="223" name=""/>
            <p:cNvGrpSpPr/>
            <p:nvPr/>
          </p:nvGrpSpPr>
          <p:grpSpPr>
            <a:xfrm>
              <a:off x="4597560" y="0"/>
              <a:ext cx="4406760" cy="6065280"/>
              <a:chOff x="4597560" y="0"/>
              <a:chExt cx="4406760" cy="6065280"/>
            </a:xfrm>
          </p:grpSpPr>
          <p:sp>
            <p:nvSpPr>
              <p:cNvPr id="224" name=""/>
              <p:cNvSpPr/>
              <p:nvPr/>
            </p:nvSpPr>
            <p:spPr>
              <a:xfrm>
                <a:off x="4861440" y="520560"/>
                <a:ext cx="400320" cy="456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5000" bIns="450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00000"/>
                    <a:tab algn="l" pos="1800360"/>
                    <a:tab algn="l" pos="2700360"/>
                    <a:tab algn="l" pos="3600360"/>
                    <a:tab algn="l" pos="4500720"/>
                    <a:tab algn="l" pos="5400720"/>
                    <a:tab algn="l" pos="6300720"/>
                    <a:tab algn="l" pos="7201080"/>
                    <a:tab algn="l" pos="8101080"/>
                    <a:tab algn="l" pos="9001080"/>
                    <a:tab algn="l" pos="9901080"/>
                    <a:tab algn="l" pos="10801440"/>
                  </a:tabLst>
                </a:pPr>
                <a:r>
                  <a:rPr b="1" lang="en-US" sz="24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endParaRPr b="0" lang="en-US" sz="2400" spc="-1" strike="noStrike">
                  <a:solidFill>
                    <a:srgbClr val="ffffff"/>
                  </a:solidFill>
                  <a:latin typeface="Times New Roman"/>
                </a:endParaRPr>
              </a:p>
            </p:txBody>
          </p:sp>
          <p:grpSp>
            <p:nvGrpSpPr>
              <p:cNvPr id="225" name=""/>
              <p:cNvGrpSpPr/>
              <p:nvPr/>
            </p:nvGrpSpPr>
            <p:grpSpPr>
              <a:xfrm>
                <a:off x="4597560" y="0"/>
                <a:ext cx="4406760" cy="6065280"/>
                <a:chOff x="4597560" y="0"/>
                <a:chExt cx="4406760" cy="6065280"/>
              </a:xfrm>
            </p:grpSpPr>
            <p:sp>
              <p:nvSpPr>
                <p:cNvPr id="226" name=""/>
                <p:cNvSpPr/>
                <p:nvPr/>
              </p:nvSpPr>
              <p:spPr>
                <a:xfrm>
                  <a:off x="5629320" y="1914480"/>
                  <a:ext cx="352440" cy="189000"/>
                </a:xfrm>
                <a:prstGeom prst="rect">
                  <a:avLst/>
                </a:prstGeom>
                <a:solidFill>
                  <a:srgbClr val="ffffff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27" name=""/>
                <p:cNvSpPr/>
                <p:nvPr/>
              </p:nvSpPr>
              <p:spPr>
                <a:xfrm>
                  <a:off x="6521400" y="1263600"/>
                  <a:ext cx="363600" cy="839880"/>
                </a:xfrm>
                <a:prstGeom prst="rect">
                  <a:avLst/>
                </a:prstGeom>
                <a:solidFill>
                  <a:srgbClr val="c0c0c0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28" name=""/>
                <p:cNvSpPr/>
                <p:nvPr/>
              </p:nvSpPr>
              <p:spPr>
                <a:xfrm>
                  <a:off x="7424640" y="2019240"/>
                  <a:ext cx="354240" cy="84240"/>
                </a:xfrm>
                <a:prstGeom prst="rect">
                  <a:avLst/>
                </a:prstGeom>
                <a:solidFill>
                  <a:srgbClr val="000000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7440" bIns="3744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29" name=""/>
                <p:cNvSpPr/>
                <p:nvPr/>
              </p:nvSpPr>
              <p:spPr>
                <a:xfrm>
                  <a:off x="8318520" y="1947960"/>
                  <a:ext cx="352440" cy="155520"/>
                </a:xfrm>
                <a:prstGeom prst="rect">
                  <a:avLst/>
                </a:prstGeom>
                <a:blipFill rotWithShape="0">
                  <a:blip r:embed="rId4"/>
                  <a:srcRect/>
                  <a:tile tx="0" ty="0" sx="100000" sy="100000" algn="ctr"/>
                </a:blip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30" name=""/>
                <p:cNvSpPr/>
                <p:nvPr/>
              </p:nvSpPr>
              <p:spPr>
                <a:xfrm flipV="1">
                  <a:off x="5805360" y="1892160"/>
                  <a:ext cx="1800" cy="2232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31" name=""/>
                <p:cNvSpPr/>
                <p:nvPr/>
              </p:nvSpPr>
              <p:spPr>
                <a:xfrm>
                  <a:off x="5772240" y="1888920"/>
                  <a:ext cx="71280" cy="1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32" name=""/>
                <p:cNvSpPr/>
                <p:nvPr/>
              </p:nvSpPr>
              <p:spPr>
                <a:xfrm flipV="1">
                  <a:off x="6697800" y="1185840"/>
                  <a:ext cx="1440" cy="777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0960" bIns="3096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33" name=""/>
                <p:cNvSpPr/>
                <p:nvPr/>
              </p:nvSpPr>
              <p:spPr>
                <a:xfrm>
                  <a:off x="6659640" y="1185840"/>
                  <a:ext cx="74520" cy="144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34" name=""/>
                <p:cNvSpPr/>
                <p:nvPr/>
              </p:nvSpPr>
              <p:spPr>
                <a:xfrm flipV="1">
                  <a:off x="7591320" y="1981080"/>
                  <a:ext cx="1800" cy="38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8640" bIns="-864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35" name=""/>
                <p:cNvSpPr/>
                <p:nvPr/>
              </p:nvSpPr>
              <p:spPr>
                <a:xfrm>
                  <a:off x="7556400" y="1977840"/>
                  <a:ext cx="73080" cy="1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36" name=""/>
                <p:cNvSpPr/>
                <p:nvPr/>
              </p:nvSpPr>
              <p:spPr>
                <a:xfrm flipV="1">
                  <a:off x="8485200" y="1909800"/>
                  <a:ext cx="1440" cy="38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8640" bIns="-864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37" name=""/>
                <p:cNvSpPr/>
                <p:nvPr/>
              </p:nvSpPr>
              <p:spPr>
                <a:xfrm>
                  <a:off x="8450280" y="1909800"/>
                  <a:ext cx="71280" cy="144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38" name=""/>
                <p:cNvSpPr/>
                <p:nvPr/>
              </p:nvSpPr>
              <p:spPr>
                <a:xfrm>
                  <a:off x="5359320" y="1006560"/>
                  <a:ext cx="1800" cy="11001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39" name=""/>
                <p:cNvSpPr/>
                <p:nvPr/>
              </p:nvSpPr>
              <p:spPr>
                <a:xfrm>
                  <a:off x="5332320" y="2100240"/>
                  <a:ext cx="20880" cy="14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40" name=""/>
                <p:cNvSpPr/>
                <p:nvPr/>
              </p:nvSpPr>
              <p:spPr>
                <a:xfrm>
                  <a:off x="5332320" y="1963800"/>
                  <a:ext cx="20880" cy="14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41" name=""/>
                <p:cNvSpPr/>
                <p:nvPr/>
              </p:nvSpPr>
              <p:spPr>
                <a:xfrm>
                  <a:off x="5332320" y="1832040"/>
                  <a:ext cx="20880" cy="14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42" name=""/>
                <p:cNvSpPr/>
                <p:nvPr/>
              </p:nvSpPr>
              <p:spPr>
                <a:xfrm>
                  <a:off x="5332320" y="1692360"/>
                  <a:ext cx="20880" cy="14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43" name=""/>
                <p:cNvSpPr/>
                <p:nvPr/>
              </p:nvSpPr>
              <p:spPr>
                <a:xfrm>
                  <a:off x="5332320" y="1554120"/>
                  <a:ext cx="20880" cy="14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44" name=""/>
                <p:cNvSpPr/>
                <p:nvPr/>
              </p:nvSpPr>
              <p:spPr>
                <a:xfrm>
                  <a:off x="5332320" y="1414440"/>
                  <a:ext cx="20880" cy="14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45" name=""/>
                <p:cNvSpPr/>
                <p:nvPr/>
              </p:nvSpPr>
              <p:spPr>
                <a:xfrm>
                  <a:off x="5332320" y="1281240"/>
                  <a:ext cx="20880" cy="14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46" name=""/>
                <p:cNvSpPr/>
                <p:nvPr/>
              </p:nvSpPr>
              <p:spPr>
                <a:xfrm>
                  <a:off x="5332320" y="1143000"/>
                  <a:ext cx="20880" cy="14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47" name=""/>
                <p:cNvSpPr/>
                <p:nvPr/>
              </p:nvSpPr>
              <p:spPr>
                <a:xfrm>
                  <a:off x="5332320" y="1012680"/>
                  <a:ext cx="20880" cy="18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48" name=""/>
                <p:cNvSpPr/>
                <p:nvPr/>
              </p:nvSpPr>
              <p:spPr>
                <a:xfrm>
                  <a:off x="5359320" y="2103480"/>
                  <a:ext cx="3581640" cy="14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49" name=""/>
                <p:cNvSpPr/>
                <p:nvPr/>
              </p:nvSpPr>
              <p:spPr>
                <a:xfrm flipV="1">
                  <a:off x="5365800" y="2103120"/>
                  <a:ext cx="1440" cy="111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50" name=""/>
                <p:cNvSpPr/>
                <p:nvPr/>
              </p:nvSpPr>
              <p:spPr>
                <a:xfrm flipV="1">
                  <a:off x="6251760" y="2109240"/>
                  <a:ext cx="1440" cy="111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51" name=""/>
                <p:cNvSpPr/>
                <p:nvPr/>
              </p:nvSpPr>
              <p:spPr>
                <a:xfrm flipV="1">
                  <a:off x="7155000" y="2109240"/>
                  <a:ext cx="1440" cy="111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52" name=""/>
                <p:cNvSpPr/>
                <p:nvPr/>
              </p:nvSpPr>
              <p:spPr>
                <a:xfrm flipV="1">
                  <a:off x="8048520" y="2109240"/>
                  <a:ext cx="1800" cy="111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53" name=""/>
                <p:cNvSpPr/>
                <p:nvPr/>
              </p:nvSpPr>
              <p:spPr>
                <a:xfrm>
                  <a:off x="5220360" y="2039760"/>
                  <a:ext cx="8604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12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54" name=""/>
                <p:cNvSpPr/>
                <p:nvPr/>
              </p:nvSpPr>
              <p:spPr>
                <a:xfrm>
                  <a:off x="5135760" y="1901880"/>
                  <a:ext cx="17136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endParaRPr b="0" lang="en-US" sz="12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55" name=""/>
                <p:cNvSpPr/>
                <p:nvPr/>
              </p:nvSpPr>
              <p:spPr>
                <a:xfrm>
                  <a:off x="5135760" y="1768320"/>
                  <a:ext cx="17136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20</a:t>
                  </a:r>
                  <a:endParaRPr b="0" lang="en-US" sz="12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56" name=""/>
                <p:cNvSpPr/>
                <p:nvPr/>
              </p:nvSpPr>
              <p:spPr>
                <a:xfrm>
                  <a:off x="5135760" y="1628640"/>
                  <a:ext cx="17136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30</a:t>
                  </a:r>
                  <a:endParaRPr b="0" lang="en-US" sz="12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57" name=""/>
                <p:cNvSpPr/>
                <p:nvPr/>
              </p:nvSpPr>
              <p:spPr>
                <a:xfrm>
                  <a:off x="5135760" y="1490760"/>
                  <a:ext cx="17136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40</a:t>
                  </a:r>
                  <a:endParaRPr b="0" lang="en-US" sz="12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58" name=""/>
                <p:cNvSpPr/>
                <p:nvPr/>
              </p:nvSpPr>
              <p:spPr>
                <a:xfrm>
                  <a:off x="5135760" y="1351080"/>
                  <a:ext cx="17136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50</a:t>
                  </a:r>
                  <a:endParaRPr b="0" lang="en-US" sz="12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59" name=""/>
                <p:cNvSpPr/>
                <p:nvPr/>
              </p:nvSpPr>
              <p:spPr>
                <a:xfrm>
                  <a:off x="5135760" y="1217520"/>
                  <a:ext cx="17136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60</a:t>
                  </a:r>
                  <a:endParaRPr b="0" lang="en-US" sz="12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60" name=""/>
                <p:cNvSpPr/>
                <p:nvPr/>
              </p:nvSpPr>
              <p:spPr>
                <a:xfrm>
                  <a:off x="5135760" y="1079280"/>
                  <a:ext cx="17136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70</a:t>
                  </a:r>
                  <a:endParaRPr b="0" lang="en-US" sz="12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61" name=""/>
                <p:cNvSpPr/>
                <p:nvPr/>
              </p:nvSpPr>
              <p:spPr>
                <a:xfrm>
                  <a:off x="5135760" y="939600"/>
                  <a:ext cx="17136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80</a:t>
                  </a:r>
                  <a:endParaRPr b="0" lang="en-US" sz="12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62" name=""/>
                <p:cNvSpPr/>
                <p:nvPr/>
              </p:nvSpPr>
              <p:spPr>
                <a:xfrm rot="16200000">
                  <a:off x="3571920" y="3093840"/>
                  <a:ext cx="2325600" cy="2746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800" spc="-1" strike="noStrike">
                      <a:solidFill>
                        <a:srgbClr val="000000"/>
                      </a:solidFill>
                      <a:latin typeface="Arial"/>
                    </a:rPr>
                    <a:t>Averege  Difference</a:t>
                  </a:r>
                  <a:endParaRPr b="0" lang="en-US" sz="18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63" name=""/>
                <p:cNvSpPr/>
                <p:nvPr/>
              </p:nvSpPr>
              <p:spPr>
                <a:xfrm>
                  <a:off x="5641920" y="3708360"/>
                  <a:ext cx="365040" cy="168120"/>
                </a:xfrm>
                <a:prstGeom prst="rect">
                  <a:avLst/>
                </a:prstGeom>
                <a:solidFill>
                  <a:srgbClr val="ffffff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64" name=""/>
                <p:cNvSpPr/>
                <p:nvPr/>
              </p:nvSpPr>
              <p:spPr>
                <a:xfrm>
                  <a:off x="6545160" y="3138480"/>
                  <a:ext cx="366840" cy="738000"/>
                </a:xfrm>
                <a:prstGeom prst="rect">
                  <a:avLst/>
                </a:prstGeom>
                <a:solidFill>
                  <a:srgbClr val="c0c0c0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65" name=""/>
                <p:cNvSpPr/>
                <p:nvPr/>
              </p:nvSpPr>
              <p:spPr>
                <a:xfrm>
                  <a:off x="7450200" y="3448080"/>
                  <a:ext cx="355680" cy="428400"/>
                </a:xfrm>
                <a:prstGeom prst="rect">
                  <a:avLst/>
                </a:prstGeom>
                <a:solidFill>
                  <a:srgbClr val="000000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66" name=""/>
                <p:cNvSpPr/>
                <p:nvPr/>
              </p:nvSpPr>
              <p:spPr>
                <a:xfrm>
                  <a:off x="8345520" y="3039840"/>
                  <a:ext cx="365040" cy="836640"/>
                </a:xfrm>
                <a:prstGeom prst="rect">
                  <a:avLst/>
                </a:prstGeom>
                <a:blipFill rotWithShape="0">
                  <a:blip r:embed="rId5"/>
                  <a:srcRect/>
                  <a:tile tx="0" ty="0" sx="100000" sy="100000" algn="ctr"/>
                </a:blip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67" name=""/>
                <p:cNvSpPr/>
                <p:nvPr/>
              </p:nvSpPr>
              <p:spPr>
                <a:xfrm flipV="1">
                  <a:off x="5813280" y="3686040"/>
                  <a:ext cx="1800" cy="2232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68" name=""/>
                <p:cNvSpPr/>
                <p:nvPr/>
              </p:nvSpPr>
              <p:spPr>
                <a:xfrm>
                  <a:off x="5775480" y="3686040"/>
                  <a:ext cx="74520" cy="1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69" name=""/>
                <p:cNvSpPr/>
                <p:nvPr/>
              </p:nvSpPr>
              <p:spPr>
                <a:xfrm flipV="1">
                  <a:off x="6718320" y="3057120"/>
                  <a:ext cx="1440" cy="810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4200" bIns="342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70" name=""/>
                <p:cNvSpPr/>
                <p:nvPr/>
              </p:nvSpPr>
              <p:spPr>
                <a:xfrm>
                  <a:off x="6678720" y="3057480"/>
                  <a:ext cx="75960" cy="144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71" name=""/>
                <p:cNvSpPr/>
                <p:nvPr/>
              </p:nvSpPr>
              <p:spPr>
                <a:xfrm flipV="1">
                  <a:off x="7623360" y="3309840"/>
                  <a:ext cx="1440" cy="13824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72" name=""/>
                <p:cNvSpPr/>
                <p:nvPr/>
              </p:nvSpPr>
              <p:spPr>
                <a:xfrm>
                  <a:off x="7585200" y="3306600"/>
                  <a:ext cx="74520" cy="1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73" name=""/>
                <p:cNvSpPr/>
                <p:nvPr/>
              </p:nvSpPr>
              <p:spPr>
                <a:xfrm flipV="1">
                  <a:off x="8528040" y="2895120"/>
                  <a:ext cx="1440" cy="1443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74" name=""/>
                <p:cNvSpPr/>
                <p:nvPr/>
              </p:nvSpPr>
              <p:spPr>
                <a:xfrm>
                  <a:off x="8489880" y="2895480"/>
                  <a:ext cx="74880" cy="1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75" name=""/>
                <p:cNvSpPr/>
                <p:nvPr/>
              </p:nvSpPr>
              <p:spPr>
                <a:xfrm>
                  <a:off x="5370480" y="2759040"/>
                  <a:ext cx="1800" cy="11415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76" name=""/>
                <p:cNvSpPr/>
                <p:nvPr/>
              </p:nvSpPr>
              <p:spPr>
                <a:xfrm>
                  <a:off x="5349960" y="3900600"/>
                  <a:ext cx="20520" cy="14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77" name=""/>
                <p:cNvSpPr/>
                <p:nvPr/>
              </p:nvSpPr>
              <p:spPr>
                <a:xfrm>
                  <a:off x="5349960" y="3711600"/>
                  <a:ext cx="20520" cy="14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78" name=""/>
                <p:cNvSpPr/>
                <p:nvPr/>
              </p:nvSpPr>
              <p:spPr>
                <a:xfrm>
                  <a:off x="5349960" y="3519360"/>
                  <a:ext cx="20520" cy="18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79" name=""/>
                <p:cNvSpPr/>
                <p:nvPr/>
              </p:nvSpPr>
              <p:spPr>
                <a:xfrm>
                  <a:off x="5349960" y="3330360"/>
                  <a:ext cx="20520" cy="18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80" name=""/>
                <p:cNvSpPr/>
                <p:nvPr/>
              </p:nvSpPr>
              <p:spPr>
                <a:xfrm>
                  <a:off x="5349960" y="3139920"/>
                  <a:ext cx="20520" cy="18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81" name=""/>
                <p:cNvSpPr/>
                <p:nvPr/>
              </p:nvSpPr>
              <p:spPr>
                <a:xfrm>
                  <a:off x="5349960" y="2949480"/>
                  <a:ext cx="20520" cy="18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82" name=""/>
                <p:cNvSpPr/>
                <p:nvPr/>
              </p:nvSpPr>
              <p:spPr>
                <a:xfrm>
                  <a:off x="5349960" y="2763720"/>
                  <a:ext cx="20520" cy="18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83" name=""/>
                <p:cNvSpPr/>
                <p:nvPr/>
              </p:nvSpPr>
              <p:spPr>
                <a:xfrm>
                  <a:off x="5370480" y="3876480"/>
                  <a:ext cx="36100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84" name=""/>
                <p:cNvSpPr/>
                <p:nvPr/>
              </p:nvSpPr>
              <p:spPr>
                <a:xfrm flipV="1">
                  <a:off x="5370480" y="3900600"/>
                  <a:ext cx="1800" cy="108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85" name=""/>
                <p:cNvSpPr/>
                <p:nvPr/>
              </p:nvSpPr>
              <p:spPr>
                <a:xfrm flipV="1">
                  <a:off x="6276960" y="3882600"/>
                  <a:ext cx="1800" cy="111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86" name=""/>
                <p:cNvSpPr/>
                <p:nvPr/>
              </p:nvSpPr>
              <p:spPr>
                <a:xfrm flipV="1">
                  <a:off x="7182000" y="3882600"/>
                  <a:ext cx="1440" cy="111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87" name=""/>
                <p:cNvSpPr/>
                <p:nvPr/>
              </p:nvSpPr>
              <p:spPr>
                <a:xfrm flipV="1">
                  <a:off x="8075520" y="3882600"/>
                  <a:ext cx="0" cy="111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88" name=""/>
                <p:cNvSpPr/>
                <p:nvPr/>
              </p:nvSpPr>
              <p:spPr>
                <a:xfrm>
                  <a:off x="5236200" y="3822480"/>
                  <a:ext cx="8604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12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89" name=""/>
                <p:cNvSpPr/>
                <p:nvPr/>
              </p:nvSpPr>
              <p:spPr>
                <a:xfrm>
                  <a:off x="5066640" y="3659040"/>
                  <a:ext cx="25668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500</a:t>
                  </a:r>
                  <a:endParaRPr b="0" lang="en-US" sz="12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90" name=""/>
                <p:cNvSpPr/>
                <p:nvPr/>
              </p:nvSpPr>
              <p:spPr>
                <a:xfrm>
                  <a:off x="4982040" y="3468600"/>
                  <a:ext cx="34200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1000</a:t>
                  </a:r>
                  <a:endParaRPr b="0" lang="en-US" sz="12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91" name=""/>
                <p:cNvSpPr/>
                <p:nvPr/>
              </p:nvSpPr>
              <p:spPr>
                <a:xfrm>
                  <a:off x="4982040" y="3278160"/>
                  <a:ext cx="34200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1500</a:t>
                  </a:r>
                  <a:endParaRPr b="0" lang="en-US" sz="12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92" name=""/>
                <p:cNvSpPr/>
                <p:nvPr/>
              </p:nvSpPr>
              <p:spPr>
                <a:xfrm>
                  <a:off x="4982040" y="3076560"/>
                  <a:ext cx="34200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2000</a:t>
                  </a:r>
                  <a:endParaRPr b="0" lang="en-US" sz="12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93" name=""/>
                <p:cNvSpPr/>
                <p:nvPr/>
              </p:nvSpPr>
              <p:spPr>
                <a:xfrm>
                  <a:off x="4982040" y="2897280"/>
                  <a:ext cx="34200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2500</a:t>
                  </a:r>
                  <a:endParaRPr b="0" lang="en-US" sz="12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94" name=""/>
                <p:cNvSpPr/>
                <p:nvPr/>
              </p:nvSpPr>
              <p:spPr>
                <a:xfrm>
                  <a:off x="4982040" y="2708280"/>
                  <a:ext cx="34200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3000</a:t>
                  </a:r>
                  <a:endParaRPr b="0" lang="en-US" sz="12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95" name=""/>
                <p:cNvSpPr/>
                <p:nvPr/>
              </p:nvSpPr>
              <p:spPr>
                <a:xfrm>
                  <a:off x="5649840" y="5445000"/>
                  <a:ext cx="368280" cy="58680"/>
                </a:xfrm>
                <a:prstGeom prst="rect">
                  <a:avLst/>
                </a:prstGeom>
                <a:solidFill>
                  <a:srgbClr val="ffffff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1880" bIns="1188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96" name=""/>
                <p:cNvSpPr/>
                <p:nvPr/>
              </p:nvSpPr>
              <p:spPr>
                <a:xfrm>
                  <a:off x="6559560" y="5283000"/>
                  <a:ext cx="368280" cy="220680"/>
                </a:xfrm>
                <a:prstGeom prst="rect">
                  <a:avLst/>
                </a:prstGeom>
                <a:solidFill>
                  <a:srgbClr val="c0c0c0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97" name=""/>
                <p:cNvSpPr/>
                <p:nvPr/>
              </p:nvSpPr>
              <p:spPr>
                <a:xfrm>
                  <a:off x="7469280" y="4949640"/>
                  <a:ext cx="355680" cy="554040"/>
                </a:xfrm>
                <a:prstGeom prst="rect">
                  <a:avLst/>
                </a:prstGeom>
                <a:solidFill>
                  <a:srgbClr val="000000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98" name=""/>
                <p:cNvSpPr/>
                <p:nvPr/>
              </p:nvSpPr>
              <p:spPr>
                <a:xfrm>
                  <a:off x="8366040" y="4672080"/>
                  <a:ext cx="368280" cy="831600"/>
                </a:xfrm>
                <a:prstGeom prst="rect">
                  <a:avLst/>
                </a:prstGeom>
                <a:blipFill rotWithShape="0">
                  <a:blip r:embed="rId6"/>
                  <a:srcRect/>
                  <a:tile tx="0" ty="0" sx="100000" sy="100000" algn="ctr"/>
                </a:blip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299" name=""/>
                <p:cNvSpPr/>
                <p:nvPr/>
              </p:nvSpPr>
              <p:spPr>
                <a:xfrm flipV="1">
                  <a:off x="5823000" y="5433480"/>
                  <a:ext cx="1440" cy="111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300" name=""/>
                <p:cNvSpPr/>
                <p:nvPr/>
              </p:nvSpPr>
              <p:spPr>
                <a:xfrm>
                  <a:off x="5788080" y="5430960"/>
                  <a:ext cx="76320" cy="144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301" name=""/>
                <p:cNvSpPr/>
                <p:nvPr/>
              </p:nvSpPr>
              <p:spPr>
                <a:xfrm flipV="1">
                  <a:off x="6732720" y="5255640"/>
                  <a:ext cx="1440" cy="270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9800" bIns="-19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302" name=""/>
                <p:cNvSpPr/>
                <p:nvPr/>
              </p:nvSpPr>
              <p:spPr>
                <a:xfrm>
                  <a:off x="6697800" y="5253120"/>
                  <a:ext cx="75960" cy="144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303" name=""/>
                <p:cNvSpPr/>
                <p:nvPr/>
              </p:nvSpPr>
              <p:spPr>
                <a:xfrm flipV="1">
                  <a:off x="7642080" y="4790520"/>
                  <a:ext cx="1800" cy="15876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304" name=""/>
                <p:cNvSpPr/>
                <p:nvPr/>
              </p:nvSpPr>
              <p:spPr>
                <a:xfrm>
                  <a:off x="7605720" y="4790880"/>
                  <a:ext cx="76320" cy="1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305" name=""/>
                <p:cNvSpPr/>
                <p:nvPr/>
              </p:nvSpPr>
              <p:spPr>
                <a:xfrm flipV="1">
                  <a:off x="8550360" y="4549680"/>
                  <a:ext cx="1440" cy="1224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306" name=""/>
                <p:cNvSpPr/>
                <p:nvPr/>
              </p:nvSpPr>
              <p:spPr>
                <a:xfrm>
                  <a:off x="8513640" y="4549680"/>
                  <a:ext cx="76320" cy="1800"/>
                </a:xfrm>
                <a:prstGeom prst="line">
                  <a:avLst/>
                </a:prstGeom>
                <a:ln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307" name=""/>
                <p:cNvSpPr/>
                <p:nvPr/>
              </p:nvSpPr>
              <p:spPr>
                <a:xfrm>
                  <a:off x="5380200" y="4443480"/>
                  <a:ext cx="1440" cy="10602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308" name=""/>
                <p:cNvSpPr/>
                <p:nvPr/>
              </p:nvSpPr>
              <p:spPr>
                <a:xfrm>
                  <a:off x="5359320" y="5503680"/>
                  <a:ext cx="20880" cy="18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309" name=""/>
                <p:cNvSpPr/>
                <p:nvPr/>
              </p:nvSpPr>
              <p:spPr>
                <a:xfrm>
                  <a:off x="5359320" y="5325840"/>
                  <a:ext cx="20880" cy="18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310" name=""/>
                <p:cNvSpPr/>
                <p:nvPr/>
              </p:nvSpPr>
              <p:spPr>
                <a:xfrm>
                  <a:off x="5359320" y="5149800"/>
                  <a:ext cx="20880" cy="14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311" name=""/>
                <p:cNvSpPr/>
                <p:nvPr/>
              </p:nvSpPr>
              <p:spPr>
                <a:xfrm>
                  <a:off x="5359320" y="4971960"/>
                  <a:ext cx="20880" cy="18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312" name=""/>
                <p:cNvSpPr/>
                <p:nvPr/>
              </p:nvSpPr>
              <p:spPr>
                <a:xfrm>
                  <a:off x="5359320" y="4795920"/>
                  <a:ext cx="20880" cy="14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313" name=""/>
                <p:cNvSpPr/>
                <p:nvPr/>
              </p:nvSpPr>
              <p:spPr>
                <a:xfrm>
                  <a:off x="5359320" y="4618080"/>
                  <a:ext cx="20880" cy="14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314" name=""/>
                <p:cNvSpPr/>
                <p:nvPr/>
              </p:nvSpPr>
              <p:spPr>
                <a:xfrm>
                  <a:off x="5359320" y="4449600"/>
                  <a:ext cx="20880" cy="18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315" name=""/>
                <p:cNvSpPr/>
                <p:nvPr/>
              </p:nvSpPr>
              <p:spPr>
                <a:xfrm>
                  <a:off x="5380200" y="5503680"/>
                  <a:ext cx="3624120" cy="18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316" name=""/>
                <p:cNvSpPr/>
                <p:nvPr/>
              </p:nvSpPr>
              <p:spPr>
                <a:xfrm flipV="1">
                  <a:off x="5380200" y="5503320"/>
                  <a:ext cx="1440" cy="111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317" name=""/>
                <p:cNvSpPr/>
                <p:nvPr/>
              </p:nvSpPr>
              <p:spPr>
                <a:xfrm flipV="1">
                  <a:off x="6289560" y="5503320"/>
                  <a:ext cx="1800" cy="111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318" name=""/>
                <p:cNvSpPr/>
                <p:nvPr/>
              </p:nvSpPr>
              <p:spPr>
                <a:xfrm flipV="1">
                  <a:off x="7199280" y="5503320"/>
                  <a:ext cx="1800" cy="111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319" name=""/>
                <p:cNvSpPr/>
                <p:nvPr/>
              </p:nvSpPr>
              <p:spPr>
                <a:xfrm flipV="1">
                  <a:off x="8094600" y="5503320"/>
                  <a:ext cx="1800" cy="111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320" name=""/>
                <p:cNvSpPr/>
                <p:nvPr/>
              </p:nvSpPr>
              <p:spPr>
                <a:xfrm>
                  <a:off x="5236200" y="5452920"/>
                  <a:ext cx="8604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12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321" name=""/>
                <p:cNvSpPr/>
                <p:nvPr/>
              </p:nvSpPr>
              <p:spPr>
                <a:xfrm>
                  <a:off x="5066640" y="5276880"/>
                  <a:ext cx="25668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500</a:t>
                  </a:r>
                  <a:endParaRPr b="0" lang="en-US" sz="12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322" name=""/>
                <p:cNvSpPr/>
                <p:nvPr/>
              </p:nvSpPr>
              <p:spPr>
                <a:xfrm>
                  <a:off x="4982040" y="5099040"/>
                  <a:ext cx="34200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1000</a:t>
                  </a:r>
                  <a:endParaRPr b="0" lang="en-US" sz="12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323" name=""/>
                <p:cNvSpPr/>
                <p:nvPr/>
              </p:nvSpPr>
              <p:spPr>
                <a:xfrm>
                  <a:off x="4982040" y="4922640"/>
                  <a:ext cx="34200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1500</a:t>
                  </a:r>
                  <a:endParaRPr b="0" lang="en-US" sz="12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324" name=""/>
                <p:cNvSpPr/>
                <p:nvPr/>
              </p:nvSpPr>
              <p:spPr>
                <a:xfrm>
                  <a:off x="4982040" y="4745160"/>
                  <a:ext cx="34200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2000</a:t>
                  </a:r>
                  <a:endParaRPr b="0" lang="en-US" sz="12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325" name=""/>
                <p:cNvSpPr/>
                <p:nvPr/>
              </p:nvSpPr>
              <p:spPr>
                <a:xfrm>
                  <a:off x="4982040" y="4568760"/>
                  <a:ext cx="34200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2500</a:t>
                  </a:r>
                  <a:endParaRPr b="0" lang="en-US" sz="12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326" name=""/>
                <p:cNvSpPr/>
                <p:nvPr/>
              </p:nvSpPr>
              <p:spPr>
                <a:xfrm>
                  <a:off x="4982040" y="4390920"/>
                  <a:ext cx="34200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3000</a:t>
                  </a:r>
                  <a:endParaRPr b="0" lang="en-US" sz="12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327" name=""/>
                <p:cNvSpPr/>
                <p:nvPr/>
              </p:nvSpPr>
              <p:spPr>
                <a:xfrm>
                  <a:off x="5654520" y="5637240"/>
                  <a:ext cx="386280" cy="213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GSH</a:t>
                  </a:r>
                  <a:endParaRPr b="0" lang="en-US" sz="1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328" name=""/>
                <p:cNvSpPr/>
                <p:nvPr/>
              </p:nvSpPr>
              <p:spPr>
                <a:xfrm>
                  <a:off x="6484680" y="5637240"/>
                  <a:ext cx="524880" cy="213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GSNO</a:t>
                  </a:r>
                  <a:endParaRPr b="0" lang="en-US" sz="1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329" name=""/>
                <p:cNvSpPr/>
                <p:nvPr/>
              </p:nvSpPr>
              <p:spPr>
                <a:xfrm>
                  <a:off x="7311960" y="5637240"/>
                  <a:ext cx="654120" cy="4266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GSH </a:t>
                  </a:r>
                  <a:endParaRPr b="0" lang="en-US" sz="1400" spc="-1" strike="noStrike">
                    <a:solidFill>
                      <a:srgbClr val="ffffff"/>
                    </a:solidFill>
                    <a:latin typeface="Times New Roman"/>
                  </a:endParaRPr>
                </a:p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cAMP</a:t>
                  </a:r>
                  <a:endParaRPr b="0" lang="en-US" sz="1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330" name=""/>
                <p:cNvSpPr/>
                <p:nvPr/>
              </p:nvSpPr>
              <p:spPr>
                <a:xfrm>
                  <a:off x="8299080" y="5638680"/>
                  <a:ext cx="524880" cy="4266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GSNO</a:t>
                  </a:r>
                  <a:endParaRPr b="0" lang="en-US" sz="1400" spc="-1" strike="noStrike">
                    <a:solidFill>
                      <a:srgbClr val="ffffff"/>
                    </a:solidFill>
                    <a:latin typeface="Times New Roman"/>
                  </a:endParaRPr>
                </a:p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cAMP</a:t>
                  </a:r>
                  <a:endParaRPr b="0" lang="en-US" sz="1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  <p:sp>
              <p:nvSpPr>
                <p:cNvPr id="331" name=""/>
                <p:cNvSpPr/>
                <p:nvPr/>
              </p:nvSpPr>
              <p:spPr>
                <a:xfrm>
                  <a:off x="6452280" y="0"/>
                  <a:ext cx="1739880" cy="456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5000" bIns="450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00000"/>
                      <a:tab algn="l" pos="1800360"/>
                      <a:tab algn="l" pos="2700360"/>
                      <a:tab algn="l" pos="3600360"/>
                      <a:tab algn="l" pos="4500720"/>
                      <a:tab algn="l" pos="5400720"/>
                      <a:tab algn="l" pos="6300720"/>
                      <a:tab algn="l" pos="7201080"/>
                      <a:tab algn="l" pos="8101080"/>
                      <a:tab algn="l" pos="9001080"/>
                      <a:tab algn="l" pos="9901080"/>
                      <a:tab algn="l" pos="10801440"/>
                    </a:tabLst>
                  </a:pPr>
                  <a:r>
                    <a:rPr b="1" lang="en-US" sz="2400" spc="-1" strike="noStrike">
                      <a:solidFill>
                        <a:srgbClr val="000000"/>
                      </a:solidFill>
                      <a:latin typeface="Arial"/>
                    </a:rPr>
                    <a:t>Microarray</a:t>
                  </a:r>
                  <a:endParaRPr b="0" lang="en-US" sz="2400" spc="-1" strike="noStrike">
                    <a:solidFill>
                      <a:srgbClr val="ffffff"/>
                    </a:solidFill>
                    <a:latin typeface="Times New Roman"/>
                  </a:endParaRPr>
                </a:p>
              </p:txBody>
            </p:sp>
          </p:grp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4-12-08T16:12:53Z</dcterms:created>
  <dc:creator>NIH</dc:creator>
  <dc:description/>
  <dc:language>en-US</dc:language>
  <cp:lastModifiedBy>CCMD NIH</cp:lastModifiedBy>
  <dcterms:modified xsi:type="dcterms:W3CDTF">2005-10-05T18:19:16Z</dcterms:modified>
  <cp:revision>22</cp:revision>
  <dc:subject/>
  <dc:title>Supplemental Figure 1 </dc:title>
</cp:coreProperties>
</file>